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8" r:id="rId1"/>
    <p:sldMasterId id="2147483873" r:id="rId2"/>
  </p:sldMasterIdLst>
  <p:notesMasterIdLst>
    <p:notesMasterId r:id="rId9"/>
  </p:notesMasterIdLst>
  <p:handoutMasterIdLst>
    <p:handoutMasterId r:id="rId10"/>
  </p:handoutMasterIdLst>
  <p:sldIdLst>
    <p:sldId id="263" r:id="rId3"/>
    <p:sldId id="270" r:id="rId4"/>
    <p:sldId id="275" r:id="rId5"/>
    <p:sldId id="277" r:id="rId6"/>
    <p:sldId id="274" r:id="rId7"/>
    <p:sldId id="273" r:id="rId8"/>
  </p:sldIdLst>
  <p:sldSz cx="13208000" cy="9906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437" userDrawn="1">
          <p15:clr>
            <a:srgbClr val="A4A3A4"/>
          </p15:clr>
        </p15:guide>
        <p15:guide id="2" orient="horz" pos="3675" userDrawn="1">
          <p15:clr>
            <a:srgbClr val="A4A3A4"/>
          </p15:clr>
        </p15:guide>
        <p15:guide id="3" orient="horz" pos="784" userDrawn="1">
          <p15:clr>
            <a:srgbClr val="A4A3A4"/>
          </p15:clr>
        </p15:guide>
        <p15:guide id="4" orient="horz" pos="576" userDrawn="1">
          <p15:clr>
            <a:srgbClr val="A4A3A4"/>
          </p15:clr>
        </p15:guide>
        <p15:guide id="5" pos="7712" userDrawn="1">
          <p15:clr>
            <a:srgbClr val="A4A3A4"/>
          </p15:clr>
        </p15:guide>
        <p15:guide id="6" pos="5339" userDrawn="1">
          <p15:clr>
            <a:srgbClr val="A4A3A4"/>
          </p15:clr>
        </p15:guide>
        <p15:guide id="8" orient="horz" pos="3536" userDrawn="1">
          <p15:clr>
            <a:srgbClr val="A4A3A4"/>
          </p15:clr>
        </p15:guide>
        <p15:guide id="10" orient="horz" pos="5266" userDrawn="1">
          <p15:clr>
            <a:srgbClr val="A4A3A4"/>
          </p15:clr>
        </p15:guide>
        <p15:guide id="11" orient="horz" pos="312" userDrawn="1">
          <p15:clr>
            <a:srgbClr val="A4A3A4"/>
          </p15:clr>
        </p15:guide>
        <p15:guide id="13" orient="horz" pos="1442" userDrawn="1">
          <p15:clr>
            <a:srgbClr val="A4A3A4"/>
          </p15:clr>
        </p15:guide>
        <p15:guide id="14" pos="645" userDrawn="1">
          <p15:clr>
            <a:srgbClr val="A4A3A4"/>
          </p15:clr>
        </p15:guide>
        <p15:guide id="16" orient="horz" pos="36" userDrawn="1">
          <p15:clr>
            <a:srgbClr val="A4A3A4"/>
          </p15:clr>
        </p15:guide>
        <p15:guide id="17" orient="horz" pos="3438" userDrawn="1">
          <p15:clr>
            <a:srgbClr val="A4A3A4"/>
          </p15:clr>
        </p15:guide>
        <p15:guide id="18" orient="horz" userDrawn="1">
          <p15:clr>
            <a:srgbClr val="A4A3A4"/>
          </p15:clr>
        </p15:guide>
        <p15:guide id="20" pos="8312" userDrawn="1">
          <p15:clr>
            <a:srgbClr val="A4A3A4"/>
          </p15:clr>
        </p15:guide>
        <p15:guide id="21" pos="4520" userDrawn="1">
          <p15:clr>
            <a:srgbClr val="A4A3A4"/>
          </p15:clr>
        </p15:guide>
        <p15:guide id="22" orient="horz" pos="2440" userDrawn="1">
          <p15:clr>
            <a:srgbClr val="A4A3A4"/>
          </p15:clr>
        </p15:guide>
        <p15:guide id="23" pos="8047" userDrawn="1">
          <p15:clr>
            <a:srgbClr val="A4A3A4"/>
          </p15:clr>
        </p15:guide>
        <p15:guide id="24" orient="horz" pos="2939" userDrawn="1">
          <p15:clr>
            <a:srgbClr val="A4A3A4"/>
          </p15:clr>
        </p15:guide>
        <p15:guide id="25" pos="248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Steve Luperchio" initials="SL" lastIdx="1" clrIdx="6">
    <p:extLst/>
  </p:cmAuthor>
  <p:cmAuthor id="1" name="Ali Haber" initials="AH" lastIdx="18" clrIdx="0">
    <p:extLst/>
  </p:cmAuthor>
  <p:cmAuthor id="8" name="Rene Russo" initials="RR" lastIdx="2" clrIdx="7">
    <p:extLst/>
  </p:cmAuthor>
  <p:cmAuthor id="2" name="Alexandra German" initials="AG" lastIdx="17" clrIdx="1">
    <p:extLst/>
  </p:cmAuthor>
  <p:cmAuthor id="9" name="Ed Campanaro" initials="MOU" lastIdx="1" clrIdx="9"/>
  <p:cmAuthor id="3" name="Stephanie Granada" initials="SG" lastIdx="33" clrIdx="2">
    <p:extLst/>
  </p:cmAuthor>
  <p:cmAuthor id="10" name="Chris Stevens" initials="CS" lastIdx="1" clrIdx="8"/>
  <p:cmAuthor id="4" name="Microsoft Office User" initials="Office" lastIdx="7" clrIdx="3">
    <p:extLst/>
  </p:cmAuthor>
  <p:cmAuthor id="11" name="michele.mutti" initials="m" lastIdx="5" clrIdx="10">
    <p:extLst/>
  </p:cmAuthor>
  <p:cmAuthor id="5" name="Microsoft Office User" initials="Office [2]" lastIdx="1" clrIdx="4">
    <p:extLst/>
  </p:cmAuthor>
  <p:cmAuthor id="12" name="valeria.szijarto" initials="v" lastIdx="5" clrIdx="11">
    <p:extLst/>
  </p:cmAuthor>
  <p:cmAuthor id="6" name="Zoltan Magyarics" initials="ZM" lastIdx="6" clrIdx="5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DCDC4"/>
    <a:srgbClr val="40E4D0"/>
    <a:srgbClr val="FF543F"/>
    <a:srgbClr val="FFD243"/>
    <a:srgbClr val="FFD85B"/>
    <a:srgbClr val="F6948A"/>
    <a:srgbClr val="0DD5CB"/>
    <a:srgbClr val="FFE48F"/>
    <a:srgbClr val="1FD7C1"/>
    <a:srgbClr val="FF8F8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25C233B-FA9F-4E1D-B899-68DEE2FC0532}" v="695" dt="2018-06-23T16:51:39.32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736" autoAdjust="0"/>
    <p:restoredTop sz="96301" autoAdjust="0"/>
  </p:normalViewPr>
  <p:slideViewPr>
    <p:cSldViewPr snapToGrid="0">
      <p:cViewPr varScale="1">
        <p:scale>
          <a:sx n="80" d="100"/>
          <a:sy n="80" d="100"/>
        </p:scale>
        <p:origin x="1608" y="60"/>
      </p:cViewPr>
      <p:guideLst>
        <p:guide orient="horz" pos="4437"/>
        <p:guide orient="horz" pos="3675"/>
        <p:guide orient="horz" pos="784"/>
        <p:guide orient="horz" pos="576"/>
        <p:guide pos="7712"/>
        <p:guide pos="5339"/>
        <p:guide orient="horz" pos="3536"/>
        <p:guide orient="horz" pos="5266"/>
        <p:guide orient="horz" pos="312"/>
        <p:guide orient="horz" pos="1442"/>
        <p:guide pos="645"/>
        <p:guide orient="horz" pos="36"/>
        <p:guide orient="horz" pos="3438"/>
        <p:guide orient="horz"/>
        <p:guide pos="8312"/>
        <p:guide pos="4520"/>
        <p:guide orient="horz" pos="2440"/>
        <p:guide pos="8047"/>
        <p:guide orient="horz" pos="2939"/>
        <p:guide pos="248"/>
      </p:guideLst>
    </p:cSldViewPr>
  </p:slideViewPr>
  <p:outlineViewPr>
    <p:cViewPr>
      <p:scale>
        <a:sx n="33" d="100"/>
        <a:sy n="33" d="100"/>
      </p:scale>
      <p:origin x="0" y="-7184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-18336"/>
    </p:cViewPr>
  </p:sorterViewPr>
  <p:notesViewPr>
    <p:cSldViewPr>
      <p:cViewPr varScale="1">
        <p:scale>
          <a:sx n="55" d="100"/>
          <a:sy n="55" d="100"/>
        </p:scale>
        <p:origin x="2844" y="96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Master" Target="slideMasters/slideMaster2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commentAuthors" Target="commentAuthors.xml"/><Relationship Id="rId5" Type="http://schemas.openxmlformats.org/officeDocument/2006/relationships/slide" Target="slides/slide3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2.xml"/><Relationship Id="rId9" Type="http://schemas.openxmlformats.org/officeDocument/2006/relationships/notesMaster" Target="notesMasters/notesMaster1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chele Mutti" userId="83e73ed629071965" providerId="LiveId" clId="{625C233B-FA9F-4E1D-B899-68DEE2FC0532}"/>
    <pc:docChg chg="undo redo custSel modSld modMainMaster">
      <pc:chgData name="Michele Mutti" userId="83e73ed629071965" providerId="LiveId" clId="{625C233B-FA9F-4E1D-B899-68DEE2FC0532}" dt="2018-06-23T16:51:39.327" v="695" actId="1036"/>
      <pc:docMkLst>
        <pc:docMk/>
      </pc:docMkLst>
      <pc:sldChg chg="addSp delSp modSp">
        <pc:chgData name="Michele Mutti" userId="83e73ed629071965" providerId="LiveId" clId="{625C233B-FA9F-4E1D-B899-68DEE2FC0532}" dt="2018-06-23T16:40:09.452" v="411" actId="1036"/>
        <pc:sldMkLst>
          <pc:docMk/>
          <pc:sldMk cId="4171998435" sldId="263"/>
        </pc:sldMkLst>
        <pc:spChg chg="mod">
          <ac:chgData name="Michele Mutti" userId="83e73ed629071965" providerId="LiveId" clId="{625C233B-FA9F-4E1D-B899-68DEE2FC0532}" dt="2018-06-23T16:32:57.949" v="71" actId="1038"/>
          <ac:spMkLst>
            <pc:docMk/>
            <pc:sldMk cId="4171998435" sldId="263"/>
            <ac:spMk id="8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57.949" v="71" actId="1038"/>
          <ac:spMkLst>
            <pc:docMk/>
            <pc:sldMk cId="4171998435" sldId="263"/>
            <ac:spMk id="10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57.949" v="71" actId="1038"/>
          <ac:spMkLst>
            <pc:docMk/>
            <pc:sldMk cId="4171998435" sldId="263"/>
            <ac:spMk id="13" creationId="{D00653FA-ED72-4115-9241-E3C5FBAF346E}"/>
          </ac:spMkLst>
        </pc:spChg>
        <pc:spChg chg="del">
          <ac:chgData name="Michele Mutti" userId="83e73ed629071965" providerId="LiveId" clId="{625C233B-FA9F-4E1D-B899-68DEE2FC0532}" dt="2018-06-23T16:32:24.810" v="3" actId="478"/>
          <ac:spMkLst>
            <pc:docMk/>
            <pc:sldMk cId="4171998435" sldId="263"/>
            <ac:spMk id="17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40:09.452" v="411" actId="1036"/>
          <ac:spMkLst>
            <pc:docMk/>
            <pc:sldMk cId="4171998435" sldId="263"/>
            <ac:spMk id="18" creationId="{00000000-0000-0000-0000-000000000000}"/>
          </ac:spMkLst>
        </pc:spChg>
        <pc:graphicFrameChg chg="del mod">
          <ac:chgData name="Michele Mutti" userId="83e73ed629071965" providerId="LiveId" clId="{625C233B-FA9F-4E1D-B899-68DEE2FC0532}" dt="2018-06-23T16:33:58.542" v="75" actId="478"/>
          <ac:graphicFrameMkLst>
            <pc:docMk/>
            <pc:sldMk cId="4171998435" sldId="263"/>
            <ac:graphicFrameMk id="12" creationId="{1F73D896-97B6-45BA-9F2F-94DB083C2FE3}"/>
          </ac:graphicFrameMkLst>
        </pc:graphicFrameChg>
        <pc:graphicFrameChg chg="del mod">
          <ac:chgData name="Michele Mutti" userId="83e73ed629071965" providerId="LiveId" clId="{625C233B-FA9F-4E1D-B899-68DEE2FC0532}" dt="2018-06-23T16:33:24.671" v="72" actId="478"/>
          <ac:graphicFrameMkLst>
            <pc:docMk/>
            <pc:sldMk cId="4171998435" sldId="263"/>
            <ac:graphicFrameMk id="39" creationId="{70ED3ADF-F54F-4639-A3A5-56476072A5E4}"/>
          </ac:graphicFrameMkLst>
        </pc:graphicFrameChg>
        <pc:picChg chg="add mod">
          <ac:chgData name="Michele Mutti" userId="83e73ed629071965" providerId="LiveId" clId="{625C233B-FA9F-4E1D-B899-68DEE2FC0532}" dt="2018-06-23T16:33:32.213" v="74" actId="1076"/>
          <ac:picMkLst>
            <pc:docMk/>
            <pc:sldMk cId="4171998435" sldId="263"/>
            <ac:picMk id="2" creationId="{6B866AC4-CBF6-4D57-8666-23366D4AA159}"/>
          </ac:picMkLst>
        </pc:picChg>
        <pc:picChg chg="add mod">
          <ac:chgData name="Michele Mutti" userId="83e73ed629071965" providerId="LiveId" clId="{625C233B-FA9F-4E1D-B899-68DEE2FC0532}" dt="2018-06-23T16:34:19.803" v="89" actId="1036"/>
          <ac:picMkLst>
            <pc:docMk/>
            <pc:sldMk cId="4171998435" sldId="263"/>
            <ac:picMk id="3" creationId="{0F0B6F2F-8333-4FBC-B427-FFA550A73414}"/>
          </ac:picMkLst>
        </pc:picChg>
      </pc:sldChg>
      <pc:sldChg chg="addSp delSp modSp">
        <pc:chgData name="Michele Mutti" userId="83e73ed629071965" providerId="LiveId" clId="{625C233B-FA9F-4E1D-B899-68DEE2FC0532}" dt="2018-06-23T16:51:39.327" v="695" actId="1036"/>
        <pc:sldMkLst>
          <pc:docMk/>
          <pc:sldMk cId="1264750923" sldId="270"/>
        </pc:sldMkLst>
        <pc:spChg chg="add del mod">
          <ac:chgData name="Michele Mutti" userId="83e73ed629071965" providerId="LiveId" clId="{625C233B-FA9F-4E1D-B899-68DEE2FC0532}" dt="2018-06-23T16:32:22.371" v="2" actId="255"/>
          <ac:spMkLst>
            <pc:docMk/>
            <pc:sldMk cId="1264750923" sldId="270"/>
            <ac:spMk id="2" creationId="{B405EBDB-09AD-40DD-9542-963060E7A106}"/>
          </ac:spMkLst>
        </pc:spChg>
        <pc:spChg chg="add mod">
          <ac:chgData name="Michele Mutti" userId="83e73ed629071965" providerId="LiveId" clId="{625C233B-FA9F-4E1D-B899-68DEE2FC0532}" dt="2018-06-23T16:40:20.241" v="412" actId="255"/>
          <ac:spMkLst>
            <pc:docMk/>
            <pc:sldMk cId="1264750923" sldId="270"/>
            <ac:spMk id="5" creationId="{B6000172-D9D3-48E8-8A8C-A2CDB8C30D3D}"/>
          </ac:spMkLst>
        </pc:spChg>
        <pc:spChg chg="mod">
          <ac:chgData name="Michele Mutti" userId="83e73ed629071965" providerId="LiveId" clId="{625C233B-FA9F-4E1D-B899-68DEE2FC0532}" dt="2018-06-23T16:38:08.936" v="281" actId="1036"/>
          <ac:spMkLst>
            <pc:docMk/>
            <pc:sldMk cId="1264750923" sldId="270"/>
            <ac:spMk id="7" creationId="{00000000-0000-0000-0000-000000000000}"/>
          </ac:spMkLst>
        </pc:spChg>
        <pc:graphicFrameChg chg="del mod">
          <ac:chgData name="Michele Mutti" userId="83e73ed629071965" providerId="LiveId" clId="{625C233B-FA9F-4E1D-B899-68DEE2FC0532}" dt="2018-06-23T16:36:17.837" v="163" actId="478"/>
          <ac:graphicFrameMkLst>
            <pc:docMk/>
            <pc:sldMk cId="1264750923" sldId="270"/>
            <ac:graphicFrameMk id="4" creationId="{0ED8EE39-ABAD-4DED-8ACA-20722398EA75}"/>
          </ac:graphicFrameMkLst>
        </pc:graphicFrameChg>
        <pc:picChg chg="add mod">
          <ac:chgData name="Michele Mutti" userId="83e73ed629071965" providerId="LiveId" clId="{625C233B-FA9F-4E1D-B899-68DEE2FC0532}" dt="2018-06-23T16:51:39.327" v="695" actId="1036"/>
          <ac:picMkLst>
            <pc:docMk/>
            <pc:sldMk cId="1264750923" sldId="270"/>
            <ac:picMk id="3" creationId="{1EA1BD12-C880-4E25-B925-DD29368E3697}"/>
          </ac:picMkLst>
        </pc:picChg>
      </pc:sldChg>
      <pc:sldChg chg="addSp modSp">
        <pc:chgData name="Michele Mutti" userId="83e73ed629071965" providerId="LiveId" clId="{625C233B-FA9F-4E1D-B899-68DEE2FC0532}" dt="2018-06-23T16:42:36.437" v="685" actId="255"/>
        <pc:sldMkLst>
          <pc:docMk/>
          <pc:sldMk cId="3673400646" sldId="273"/>
        </pc:sldMkLst>
        <pc:spChg chg="add mod">
          <ac:chgData name="Michele Mutti" userId="83e73ed629071965" providerId="LiveId" clId="{625C233B-FA9F-4E1D-B899-68DEE2FC0532}" dt="2018-06-23T16:42:36.437" v="685" actId="255"/>
          <ac:spMkLst>
            <pc:docMk/>
            <pc:sldMk cId="3673400646" sldId="273"/>
            <ac:spMk id="3" creationId="{6B73CDE4-4C7A-4C10-B5A1-B47324F03A2D}"/>
          </ac:spMkLst>
        </pc:spChg>
        <pc:spChg chg="mod">
          <ac:chgData name="Michele Mutti" userId="83e73ed629071965" providerId="LiveId" clId="{625C233B-FA9F-4E1D-B899-68DEE2FC0532}" dt="2018-06-23T16:42:30.541" v="684" actId="1037"/>
          <ac:spMkLst>
            <pc:docMk/>
            <pc:sldMk cId="3673400646" sldId="273"/>
            <ac:spMk id="6" creationId="{0AC7849A-810C-4273-A249-C8BDDD1984A1}"/>
          </ac:spMkLst>
        </pc:spChg>
        <pc:spChg chg="mod">
          <ac:chgData name="Michele Mutti" userId="83e73ed629071965" providerId="LiveId" clId="{625C233B-FA9F-4E1D-B899-68DEE2FC0532}" dt="2018-06-23T16:42:30.541" v="684" actId="1037"/>
          <ac:spMkLst>
            <pc:docMk/>
            <pc:sldMk cId="3673400646" sldId="273"/>
            <ac:spMk id="15" creationId="{8799132C-30D5-49FC-A23A-5588E2E31766}"/>
          </ac:spMkLst>
        </pc:spChg>
        <pc:spChg chg="mod">
          <ac:chgData name="Michele Mutti" userId="83e73ed629071965" providerId="LiveId" clId="{625C233B-FA9F-4E1D-B899-68DEE2FC0532}" dt="2018-06-23T16:42:30.541" v="684" actId="1037"/>
          <ac:spMkLst>
            <pc:docMk/>
            <pc:sldMk cId="3673400646" sldId="273"/>
            <ac:spMk id="16" creationId="{14AC493A-31E7-4313-8E1A-BF4C86E53D1D}"/>
          </ac:spMkLst>
        </pc:spChg>
        <pc:spChg chg="mod">
          <ac:chgData name="Michele Mutti" userId="83e73ed629071965" providerId="LiveId" clId="{625C233B-FA9F-4E1D-B899-68DEE2FC0532}" dt="2018-06-23T16:41:41.576" v="631" actId="1035"/>
          <ac:spMkLst>
            <pc:docMk/>
            <pc:sldMk cId="3673400646" sldId="273"/>
            <ac:spMk id="17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42:30.541" v="684" actId="1037"/>
          <ac:spMkLst>
            <pc:docMk/>
            <pc:sldMk cId="3673400646" sldId="273"/>
            <ac:spMk id="18" creationId="{44941643-CBFC-4AB4-96CA-D00A04C91DA3}"/>
          </ac:spMkLst>
        </pc:spChg>
        <pc:spChg chg="mod">
          <ac:chgData name="Michele Mutti" userId="83e73ed629071965" providerId="LiveId" clId="{625C233B-FA9F-4E1D-B899-68DEE2FC0532}" dt="2018-06-23T16:42:30.541" v="684" actId="1037"/>
          <ac:spMkLst>
            <pc:docMk/>
            <pc:sldMk cId="3673400646" sldId="273"/>
            <ac:spMk id="19" creationId="{EE15773A-144A-49A0-BD9B-E17571D41F81}"/>
          </ac:spMkLst>
        </pc:spChg>
        <pc:spChg chg="mod">
          <ac:chgData name="Michele Mutti" userId="83e73ed629071965" providerId="LiveId" clId="{625C233B-FA9F-4E1D-B899-68DEE2FC0532}" dt="2018-06-23T16:42:30.541" v="684" actId="1037"/>
          <ac:spMkLst>
            <pc:docMk/>
            <pc:sldMk cId="3673400646" sldId="273"/>
            <ac:spMk id="37" creationId="{B80E85DC-CFE0-4762-BFCC-85A48ED9A50A}"/>
          </ac:spMkLst>
        </pc:spChg>
        <pc:spChg chg="mod">
          <ac:chgData name="Michele Mutti" userId="83e73ed629071965" providerId="LiveId" clId="{625C233B-FA9F-4E1D-B899-68DEE2FC0532}" dt="2018-06-23T16:42:30.541" v="684" actId="1037"/>
          <ac:spMkLst>
            <pc:docMk/>
            <pc:sldMk cId="3673400646" sldId="273"/>
            <ac:spMk id="38" creationId="{D79533EF-AAD8-4429-91E5-1EE3AF670378}"/>
          </ac:spMkLst>
        </pc:spChg>
        <pc:spChg chg="mod">
          <ac:chgData name="Michele Mutti" userId="83e73ed629071965" providerId="LiveId" clId="{625C233B-FA9F-4E1D-B899-68DEE2FC0532}" dt="2018-06-23T16:42:30.541" v="684" actId="1037"/>
          <ac:spMkLst>
            <pc:docMk/>
            <pc:sldMk cId="3673400646" sldId="273"/>
            <ac:spMk id="40" creationId="{C9F96805-5EB0-4EE7-8AED-C46BC81ECFF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k cId="3673400646" sldId="273"/>
            <ac:spMk id="42" creationId="{0FE5DB57-FA5C-4AE5-9FB9-656D31F05AF0}"/>
          </ac:spMkLst>
        </pc:spChg>
        <pc:spChg chg="mod">
          <ac:chgData name="Michele Mutti" userId="83e73ed629071965" providerId="LiveId" clId="{625C233B-FA9F-4E1D-B899-68DEE2FC0532}" dt="2018-06-23T16:42:30.541" v="684" actId="1037"/>
          <ac:spMkLst>
            <pc:docMk/>
            <pc:sldMk cId="3673400646" sldId="273"/>
            <ac:spMk id="44" creationId="{D2103201-37B0-4B99-BF0C-2F41CA5A14D0}"/>
          </ac:spMkLst>
        </pc:spChg>
        <pc:grpChg chg="mod">
          <ac:chgData name="Michele Mutti" userId="83e73ed629071965" providerId="LiveId" clId="{625C233B-FA9F-4E1D-B899-68DEE2FC0532}" dt="2018-06-23T16:42:30.541" v="684" actId="1037"/>
          <ac:grpSpMkLst>
            <pc:docMk/>
            <pc:sldMk cId="3673400646" sldId="273"/>
            <ac:grpSpMk id="2" creationId="{D913A58E-EAD1-4A8A-8850-475A7501A3C1}"/>
          </ac:grpSpMkLst>
        </pc:grpChg>
        <pc:picChg chg="mod">
          <ac:chgData name="Michele Mutti" userId="83e73ed629071965" providerId="LiveId" clId="{625C233B-FA9F-4E1D-B899-68DEE2FC0532}" dt="2018-06-23T16:42:30.541" v="684" actId="1037"/>
          <ac:picMkLst>
            <pc:docMk/>
            <pc:sldMk cId="3673400646" sldId="273"/>
            <ac:picMk id="5" creationId="{2515F5F2-3A4F-4C0F-9E19-436785942237}"/>
          </ac:picMkLst>
        </pc:picChg>
      </pc:sldChg>
      <pc:sldChg chg="addSp modSp">
        <pc:chgData name="Michele Mutti" userId="83e73ed629071965" providerId="LiveId" clId="{625C233B-FA9F-4E1D-B899-68DEE2FC0532}" dt="2018-06-23T16:41:20.575" v="555" actId="255"/>
        <pc:sldMkLst>
          <pc:docMk/>
          <pc:sldMk cId="3005230339" sldId="274"/>
        </pc:sldMkLst>
        <pc:spChg chg="add mod">
          <ac:chgData name="Michele Mutti" userId="83e73ed629071965" providerId="LiveId" clId="{625C233B-FA9F-4E1D-B899-68DEE2FC0532}" dt="2018-06-23T16:41:20.575" v="555" actId="255"/>
          <ac:spMkLst>
            <pc:docMk/>
            <pc:sldMk cId="3005230339" sldId="274"/>
            <ac:spMk id="3" creationId="{C670595B-DB1D-499F-98E1-02CA624B9A6B}"/>
          </ac:spMkLst>
        </pc:spChg>
        <pc:spChg chg="mod">
          <ac:chgData name="Michele Mutti" userId="83e73ed629071965" providerId="LiveId" clId="{625C233B-FA9F-4E1D-B899-68DEE2FC0532}" dt="2018-06-23T16:40:41.479" v="483" actId="1037"/>
          <ac:spMkLst>
            <pc:docMk/>
            <pc:sldMk cId="3005230339" sldId="274"/>
            <ac:spMk id="5" creationId="{00000000-0000-0000-0000-000000000000}"/>
          </ac:spMkLst>
        </pc:spChg>
        <pc:graphicFrameChg chg="mod">
          <ac:chgData name="Michele Mutti" userId="83e73ed629071965" providerId="LiveId" clId="{625C233B-FA9F-4E1D-B899-68DEE2FC0532}" dt="2018-06-23T16:40:52.135" v="533" actId="1036"/>
          <ac:graphicFrameMkLst>
            <pc:docMk/>
            <pc:sldMk cId="3005230339" sldId="274"/>
            <ac:graphicFrameMk id="2" creationId="{FADE8BE7-4382-49D7-B50A-3ABDC89AF990}"/>
          </ac:graphicFrameMkLst>
        </pc:graphicFrameChg>
      </pc:sldChg>
      <pc:sldChg chg="addSp modSp">
        <pc:chgData name="Michele Mutti" userId="83e73ed629071965" providerId="LiveId" clId="{625C233B-FA9F-4E1D-B899-68DEE2FC0532}" dt="2018-06-23T16:40:29.034" v="413" actId="255"/>
        <pc:sldMkLst>
          <pc:docMk/>
          <pc:sldMk cId="1135612625" sldId="275"/>
        </pc:sldMkLst>
        <pc:spChg chg="add mod">
          <ac:chgData name="Michele Mutti" userId="83e73ed629071965" providerId="LiveId" clId="{625C233B-FA9F-4E1D-B899-68DEE2FC0532}" dt="2018-06-23T16:40:29.034" v="413" actId="255"/>
          <ac:spMkLst>
            <pc:docMk/>
            <pc:sldMk cId="1135612625" sldId="275"/>
            <ac:spMk id="2" creationId="{6DB4C542-9090-48AC-A55E-9C634394B95F}"/>
          </ac:spMkLst>
        </pc:spChg>
        <pc:spChg chg="mod">
          <ac:chgData name="Michele Mutti" userId="83e73ed629071965" providerId="LiveId" clId="{625C233B-FA9F-4E1D-B899-68DEE2FC0532}" dt="2018-06-23T16:38:51.527" v="302" actId="1038"/>
          <ac:spMkLst>
            <pc:docMk/>
            <pc:sldMk cId="1135612625" sldId="275"/>
            <ac:spMk id="5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6" creationId="{A07ED739-34D5-411B-B007-ADE18EA9D524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9" creationId="{939B4489-668C-4EC6-A25B-996AA61EFEA7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10" creationId="{213D33E3-AC06-4B20-97C5-20CF1AC8D914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11" creationId="{A0371865-25E0-42EC-8C6F-7BC2FA12597F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12" creationId="{90BEFA79-8B59-4FEB-9DF9-CA7F4ECE35AC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13" creationId="{9BE0A2A1-4498-40E4-BE86-0CAEF3C8336A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16" creationId="{C400EA0F-2BA6-4611-8617-F1000793546F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17" creationId="{C617C317-01D7-4480-ADD8-7D5CEC6CDD07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19" creationId="{79AF447F-DF68-4DAF-B192-E652E889E282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20" creationId="{1A5C5173-02D4-4DDC-8A98-AFC7FB622044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21" creationId="{5070FF5F-9AA0-455A-BB21-AA4AA3183866}"/>
          </ac:spMkLst>
        </pc:spChg>
        <pc:spChg chg="mod">
          <ac:chgData name="Michele Mutti" userId="83e73ed629071965" providerId="LiveId" clId="{625C233B-FA9F-4E1D-B899-68DEE2FC0532}" dt="2018-06-23T16:39:30.671" v="361" actId="1036"/>
          <ac:spMkLst>
            <pc:docMk/>
            <pc:sldMk cId="1135612625" sldId="275"/>
            <ac:spMk id="22" creationId="{54FA8EFF-E303-4B93-AC82-D9069867A586}"/>
          </ac:spMkLst>
        </pc:spChg>
        <pc:picChg chg="mod">
          <ac:chgData name="Michele Mutti" userId="83e73ed629071965" providerId="LiveId" clId="{625C233B-FA9F-4E1D-B899-68DEE2FC0532}" dt="2018-06-23T16:39:30.671" v="361" actId="1036"/>
          <ac:picMkLst>
            <pc:docMk/>
            <pc:sldMk cId="1135612625" sldId="275"/>
            <ac:picMk id="7" creationId="{6F07D5CE-4BFB-4011-88B2-BCD205CF81C9}"/>
          </ac:picMkLst>
        </pc:picChg>
      </pc:sldChg>
      <pc:sldMasterChg chg="modSp modSldLayout">
        <pc:chgData name="Michele Mutti" userId="83e73ed629071965" providerId="LiveId" clId="{625C233B-FA9F-4E1D-B899-68DEE2FC0532}" dt="2018-06-23T16:32:41.223" v="6" actId="255"/>
        <pc:sldMasterMkLst>
          <pc:docMk/>
          <pc:sldMasterMk cId="2227966291" sldId="2147483808"/>
        </pc:sldMasterMkLst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2227966291" sldId="2147483808"/>
            <ac:spMk id="2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2227966291" sldId="2147483808"/>
            <ac:spMk id="3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2227966291" sldId="2147483808"/>
            <ac:spMk id="10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2227966291" sldId="2147483808"/>
            <ac:spMk id="12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2227966291" sldId="2147483808"/>
            <ac:spMk id="13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2227966291" sldId="2147483808"/>
            <ac:spMk id="14" creationId="{00000000-0000-0000-0000-000000000000}"/>
          </ac:spMkLst>
        </pc:spChg>
        <pc:picChg chg="mod">
          <ac:chgData name="Michele Mutti" userId="83e73ed629071965" providerId="LiveId" clId="{625C233B-FA9F-4E1D-B899-68DEE2FC0532}" dt="2018-06-23T16:32:41.223" v="6" actId="255"/>
          <ac:picMkLst>
            <pc:docMk/>
            <pc:sldMasterMk cId="2227966291" sldId="2147483808"/>
            <ac:picMk id="8" creationId="{00000000-0000-0000-0000-000000000000}"/>
          </ac:picMkLst>
        </pc:picChg>
        <pc:cxnChg chg="mod">
          <ac:chgData name="Michele Mutti" userId="83e73ed629071965" providerId="LiveId" clId="{625C233B-FA9F-4E1D-B899-68DEE2FC0532}" dt="2018-06-23T16:32:41.223" v="6" actId="255"/>
          <ac:cxnSpMkLst>
            <pc:docMk/>
            <pc:sldMasterMk cId="2227966291" sldId="2147483808"/>
            <ac:cxnSpMk id="9" creationId="{00000000-0000-0000-0000-000000000000}"/>
          </ac:cxnSpMkLst>
        </pc:cxn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2227966291" sldId="2147483808"/>
            <pc:sldLayoutMk cId="145059664" sldId="2147483810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2227966291" sldId="2147483808"/>
              <pc:sldLayoutMk cId="145059664" sldId="2147483810"/>
              <ac:spMk id="3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2227966291" sldId="2147483808"/>
              <pc:sldLayoutMk cId="145059664" sldId="2147483810"/>
              <ac:spMk id="7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2227966291" sldId="2147483808"/>
            <pc:sldLayoutMk cId="3932223026" sldId="2147483814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2227966291" sldId="2147483808"/>
              <pc:sldLayoutMk cId="3932223026" sldId="2147483814"/>
              <ac:spMk id="6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2227966291" sldId="2147483808"/>
            <pc:sldLayoutMk cId="2480154409" sldId="2147483822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2227966291" sldId="2147483808"/>
              <pc:sldLayoutMk cId="2480154409" sldId="2147483822"/>
              <ac:spMk id="2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2227966291" sldId="2147483808"/>
              <pc:sldLayoutMk cId="2480154409" sldId="2147483822"/>
              <ac:spMk id="3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2227966291" sldId="2147483808"/>
              <pc:sldLayoutMk cId="2480154409" sldId="2147483822"/>
              <ac:spMk id="8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2227966291" sldId="2147483808"/>
            <pc:sldLayoutMk cId="2807523116" sldId="2147483836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2227966291" sldId="2147483808"/>
              <pc:sldLayoutMk cId="2807523116" sldId="2147483836"/>
              <ac:spMk id="2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2227966291" sldId="2147483808"/>
              <pc:sldLayoutMk cId="2807523116" sldId="2147483836"/>
              <ac:spMk id="3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2227966291" sldId="2147483808"/>
              <pc:sldLayoutMk cId="2807523116" sldId="2147483836"/>
              <ac:spMk id="8" creationId="{00000000-0000-0000-0000-000000000000}"/>
            </ac:spMkLst>
          </pc:spChg>
          <pc:picChg chg="mod">
            <ac:chgData name="Michele Mutti" userId="83e73ed629071965" providerId="LiveId" clId="{625C233B-FA9F-4E1D-B899-68DEE2FC0532}" dt="2018-06-23T16:32:41.223" v="6" actId="255"/>
            <ac:picMkLst>
              <pc:docMk/>
              <pc:sldMasterMk cId="2227966291" sldId="2147483808"/>
              <pc:sldLayoutMk cId="2807523116" sldId="2147483836"/>
              <ac:picMk id="6" creationId="{00000000-0000-0000-0000-000000000000}"/>
            </ac:picMkLst>
          </pc:picChg>
        </pc:sldLayoutChg>
      </pc:sldMasterChg>
      <pc:sldMasterChg chg="modSp modSldLayout">
        <pc:chgData name="Michele Mutti" userId="83e73ed629071965" providerId="LiveId" clId="{625C233B-FA9F-4E1D-B899-68DEE2FC0532}" dt="2018-06-23T16:32:41.223" v="6" actId="255"/>
        <pc:sldMasterMkLst>
          <pc:docMk/>
          <pc:sldMasterMk cId="3090990433" sldId="2147483855"/>
        </pc:sldMasterMkLst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3090990433" sldId="2147483855"/>
            <ac:spMk id="2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3090990433" sldId="2147483855"/>
            <ac:spMk id="3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3090990433" sldId="2147483855"/>
            <ac:spMk id="4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3090990433" sldId="2147483855"/>
            <ac:spMk id="5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3090990433" sldId="2147483855"/>
            <ac:spMk id="6" creationId="{00000000-0000-0000-0000-000000000000}"/>
          </ac:spMkLst>
        </pc:spChg>
        <pc:spChg chg="mod">
          <ac:chgData name="Michele Mutti" userId="83e73ed629071965" providerId="LiveId" clId="{625C233B-FA9F-4E1D-B899-68DEE2FC0532}" dt="2018-06-23T16:32:41.223" v="6" actId="255"/>
          <ac:spMkLst>
            <pc:docMk/>
            <pc:sldMasterMk cId="3090990433" sldId="2147483855"/>
            <ac:spMk id="7" creationId="{00000000-0000-0000-0000-000000000000}"/>
          </ac:spMkLst>
        </pc:sp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3090990433" sldId="2147483855"/>
            <pc:sldLayoutMk cId="74146443" sldId="2147483856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74146443" sldId="2147483856"/>
              <ac:spMk id="2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74146443" sldId="2147483856"/>
              <ac:spMk id="3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74146443" sldId="2147483856"/>
              <ac:spMk id="7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3090990433" sldId="2147483855"/>
            <pc:sldLayoutMk cId="2253707140" sldId="2147483858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253707140" sldId="2147483858"/>
              <ac:spMk id="2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253707140" sldId="2147483858"/>
              <ac:spMk id="3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3090990433" sldId="2147483855"/>
            <pc:sldLayoutMk cId="1952488461" sldId="2147483859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1952488461" sldId="2147483859"/>
              <ac:spMk id="3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1952488461" sldId="2147483859"/>
              <ac:spMk id="4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3090990433" sldId="2147483855"/>
            <pc:sldLayoutMk cId="3463860827" sldId="2147483860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3463860827" sldId="2147483860"/>
              <ac:spMk id="2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3463860827" sldId="2147483860"/>
              <ac:spMk id="3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3463860827" sldId="2147483860"/>
              <ac:spMk id="4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3463860827" sldId="2147483860"/>
              <ac:spMk id="5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3463860827" sldId="2147483860"/>
              <ac:spMk id="6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3090990433" sldId="2147483855"/>
            <pc:sldLayoutMk cId="2905285017" sldId="2147483863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905285017" sldId="2147483863"/>
              <ac:spMk id="2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905285017" sldId="2147483863"/>
              <ac:spMk id="3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905285017" sldId="2147483863"/>
              <ac:spMk id="4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3090990433" sldId="2147483855"/>
            <pc:sldLayoutMk cId="2053091096" sldId="2147483864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053091096" sldId="2147483864"/>
              <ac:spMk id="2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053091096" sldId="2147483864"/>
              <ac:spMk id="3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053091096" sldId="2147483864"/>
              <ac:spMk id="4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3090990433" sldId="2147483855"/>
            <pc:sldLayoutMk cId="226675122" sldId="2147483866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26675122" sldId="2147483866"/>
              <ac:spMk id="2" creationId="{00000000-0000-0000-0000-000000000000}"/>
            </ac:spMkLst>
          </pc:spChg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26675122" sldId="2147483866"/>
              <ac:spMk id="3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3090990433" sldId="2147483855"/>
            <pc:sldLayoutMk cId="385231310" sldId="2147483868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385231310" sldId="2147483868"/>
              <ac:spMk id="6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3090990433" sldId="2147483855"/>
            <pc:sldLayoutMk cId="2515702475" sldId="2147483870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2515702475" sldId="2147483870"/>
              <ac:spMk id="6" creationId="{00000000-0000-0000-0000-000000000000}"/>
            </ac:spMkLst>
          </pc:spChg>
        </pc:sldLayoutChg>
        <pc:sldLayoutChg chg="modSp">
          <pc:chgData name="Michele Mutti" userId="83e73ed629071965" providerId="LiveId" clId="{625C233B-FA9F-4E1D-B899-68DEE2FC0532}" dt="2018-06-23T16:32:41.223" v="6" actId="255"/>
          <pc:sldLayoutMkLst>
            <pc:docMk/>
            <pc:sldMasterMk cId="3090990433" sldId="2147483855"/>
            <pc:sldLayoutMk cId="4292454357" sldId="2147483872"/>
          </pc:sldLayoutMkLst>
          <pc:spChg chg="mod">
            <ac:chgData name="Michele Mutti" userId="83e73ed629071965" providerId="LiveId" clId="{625C233B-FA9F-4E1D-B899-68DEE2FC0532}" dt="2018-06-23T16:32:41.223" v="6" actId="255"/>
            <ac:spMkLst>
              <pc:docMk/>
              <pc:sldMasterMk cId="3090990433" sldId="2147483855"/>
              <pc:sldLayoutMk cId="4292454357" sldId="2147483872"/>
              <ac:spMk id="6" creationId="{00000000-0000-0000-0000-000000000000}"/>
            </ac:spMkLst>
          </pc:spChg>
        </pc:sldLayoutChg>
      </pc:sldMasterChg>
      <pc:sldMasterChg chg="addSp modSldLayout">
        <pc:chgData name="Michele Mutti" userId="83e73ed629071965" providerId="LiveId" clId="{625C233B-FA9F-4E1D-B899-68DEE2FC0532}" dt="2018-06-23T16:32:41.223" v="6" actId="255"/>
        <pc:sldMasterMkLst>
          <pc:docMk/>
          <pc:sldMasterMk cId="56952826" sldId="2147483873"/>
        </pc:sldMasterMkLst>
        <pc:spChg chg="add">
          <ac:chgData name="Michele Mutti" userId="83e73ed629071965" providerId="LiveId" clId="{625C233B-FA9F-4E1D-B899-68DEE2FC0532}" dt="2018-06-23T16:32:41.223" v="6" actId="255"/>
          <ac:spMkLst>
            <pc:docMk/>
            <pc:sldMasterMk cId="56952826" sldId="2147483873"/>
            <ac:spMk id="7" creationId="{FAFFC379-F4B7-443C-9CFF-88EEDF99E9FF}"/>
          </ac:spMkLst>
        </pc:spChg>
        <pc:sldLayoutChg chg="addSp">
          <pc:chgData name="Michele Mutti" userId="83e73ed629071965" providerId="LiveId" clId="{625C233B-FA9F-4E1D-B899-68DEE2FC0532}" dt="2018-06-23T16:32:41.223" v="6" actId="255"/>
          <pc:sldLayoutMkLst>
            <pc:docMk/>
            <pc:sldMasterMk cId="56952826" sldId="2147483873"/>
            <pc:sldLayoutMk cId="2868602846" sldId="2147483874"/>
          </pc:sldLayoutMkLst>
          <pc:spChg chg="add">
            <ac:chgData name="Michele Mutti" userId="83e73ed629071965" providerId="LiveId" clId="{625C233B-FA9F-4E1D-B899-68DEE2FC0532}" dt="2018-06-23T16:32:41.223" v="6" actId="255"/>
            <ac:spMkLst>
              <pc:docMk/>
              <pc:sldMasterMk cId="56952826" sldId="2147483873"/>
              <pc:sldLayoutMk cId="2868602846" sldId="2147483874"/>
              <ac:spMk id="7" creationId="{3150734F-3735-49AA-8EF4-49C048FABBD3}"/>
            </ac:spMkLst>
          </pc:spChg>
        </pc:sldLayoutChg>
      </pc:sldMasterChg>
      <pc:sldMasterChg chg="addSp modSldLayout">
        <pc:chgData name="Michele Mutti" userId="83e73ed629071965" providerId="LiveId" clId="{625C233B-FA9F-4E1D-B899-68DEE2FC0532}" dt="2018-06-23T16:32:32.993" v="4" actId="255"/>
        <pc:sldMasterMkLst>
          <pc:docMk/>
          <pc:sldMasterMk cId="3503072944" sldId="2147483873"/>
        </pc:sldMasterMkLst>
        <pc:spChg chg="add">
          <ac:chgData name="Michele Mutti" userId="83e73ed629071965" providerId="LiveId" clId="{625C233B-FA9F-4E1D-B899-68DEE2FC0532}" dt="2018-06-23T16:32:32.993" v="4" actId="255"/>
          <ac:spMkLst>
            <pc:docMk/>
            <pc:sldMasterMk cId="3503072944" sldId="2147483873"/>
            <ac:spMk id="7" creationId="{3544E41B-7D0E-4F97-9B78-A056DE76CEAC}"/>
          </ac:spMkLst>
        </pc:spChg>
        <pc:sldLayoutChg chg="addSp">
          <pc:chgData name="Michele Mutti" userId="83e73ed629071965" providerId="LiveId" clId="{625C233B-FA9F-4E1D-B899-68DEE2FC0532}" dt="2018-06-23T16:32:32.993" v="4" actId="255"/>
          <pc:sldLayoutMkLst>
            <pc:docMk/>
            <pc:sldMasterMk cId="3503072944" sldId="2147483873"/>
            <pc:sldLayoutMk cId="1123612241" sldId="2147483874"/>
          </pc:sldLayoutMkLst>
          <pc:spChg chg="add">
            <ac:chgData name="Michele Mutti" userId="83e73ed629071965" providerId="LiveId" clId="{625C233B-FA9F-4E1D-B899-68DEE2FC0532}" dt="2018-06-23T16:32:32.993" v="4" actId="255"/>
            <ac:spMkLst>
              <pc:docMk/>
              <pc:sldMasterMk cId="3503072944" sldId="2147483873"/>
              <pc:sldLayoutMk cId="1123612241" sldId="2147483874"/>
              <ac:spMk id="7" creationId="{0F31767F-7D46-47DE-B040-63D40E11CE4B}"/>
            </ac:spMkLst>
          </pc:spChg>
        </pc:sldLayoutChg>
      </pc:sldMasterChg>
    </pc:docChg>
  </pc:docChgLst>
</pc:chgInfo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3"/>
            <a:ext cx="2946400" cy="49688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3"/>
            <a:ext cx="2946400" cy="49688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1AE0E1-9566-4E02-A441-3D4665970977}" type="datetimeFigureOut">
              <a:rPr lang="en-US" smtClean="0"/>
              <a:t>8/20/20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1"/>
            <a:ext cx="2946400" cy="49688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1"/>
            <a:ext cx="2946400" cy="49688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956697-8954-4E26-9EAE-FAB76846EB7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2265734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7" y="0"/>
            <a:ext cx="2945659" cy="4964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9" y="0"/>
            <a:ext cx="2945659" cy="4964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ADBE5D-AAA0-4242-A14F-764C2813AAFA}" type="datetimeFigureOut">
              <a:rPr lang="en-US" smtClean="0"/>
              <a:t>8/20/20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10"/>
            <a:ext cx="5438140" cy="4467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7" y="9430093"/>
            <a:ext cx="2945659" cy="496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9" y="9430093"/>
            <a:ext cx="2945659" cy="496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C999AC-6B10-44DF-B6F8-ED556EBF8F7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3000839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756859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67232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916300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034940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23033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177731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bg>
      <p:bgPr>
        <a:blipFill rotWithShape="1">
          <a:blip r:embed="rId2"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2527458"/>
            <a:ext cx="13208000" cy="6934990"/>
          </a:xfrm>
          <a:prstGeom prst="rect">
            <a:avLst/>
          </a:prstGeom>
          <a:solidFill>
            <a:schemeClr val="bg1"/>
          </a:solidFill>
          <a:ln w="12700" cmpd="sng"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>
              <a:lnSpc>
                <a:spcPct val="95000"/>
              </a:lnSpc>
              <a:spcAft>
                <a:spcPts val="2226"/>
              </a:spcAft>
              <a:buClr>
                <a:srgbClr val="969696"/>
              </a:buClr>
              <a:buSzPct val="80000"/>
              <a:tabLst>
                <a:tab pos="1006862" algn="r"/>
                <a:tab pos="2994089" algn="r"/>
                <a:tab pos="4981315" algn="r"/>
                <a:tab pos="6995038" algn="r"/>
                <a:tab pos="8982265" algn="r"/>
                <a:tab pos="10969493" algn="r"/>
                <a:tab pos="12983216" algn="r"/>
                <a:tab pos="14970442" algn="r"/>
                <a:tab pos="16957669" algn="r"/>
                <a:tab pos="18971394" algn="r"/>
                <a:tab pos="20958620" algn="r"/>
              </a:tabLst>
            </a:pPr>
            <a:endParaRPr lang="en-US" sz="3894" noProof="1">
              <a:solidFill>
                <a:schemeClr val="tx1"/>
              </a:solidFill>
              <a:latin typeface="Calibri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60400" y="5239554"/>
            <a:ext cx="11887200" cy="710818"/>
          </a:xfrm>
        </p:spPr>
        <p:txBody>
          <a:bodyPr anchor="b" anchorCtr="0">
            <a:normAutofit/>
          </a:bodyPr>
          <a:lstStyle>
            <a:lvl1pPr>
              <a:defRPr sz="10015">
                <a:solidFill>
                  <a:srgbClr val="FF543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60400" y="6228257"/>
            <a:ext cx="9245600" cy="1321235"/>
          </a:xfrm>
        </p:spPr>
        <p:txBody>
          <a:bodyPr/>
          <a:lstStyle>
            <a:lvl1pPr marL="0" indent="0" algn="l">
              <a:buNone/>
              <a:defRPr b="1">
                <a:solidFill>
                  <a:srgbClr val="CEC4BE"/>
                </a:solidFill>
              </a:defRPr>
            </a:lvl1pPr>
            <a:lvl2pPr marL="12718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5436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8154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0873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3591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6309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89027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01746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0154409"/>
      </p:ext>
    </p:extLst>
  </p:cSld>
  <p:clrMapOvr>
    <a:masterClrMapping/>
  </p:clrMapOvr>
  <p:extLst mod="1">
    <p:ext uri="{DCECCB84-F9BA-43D5-87BE-67443E8EF086}">
      <p15:sldGuideLst xmlns:p15="http://schemas.microsoft.com/office/powerpoint/2012/main">
        <p15:guide id="1" orient="horz" pos="2877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527405"/>
            <a:ext cx="11391900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2428347"/>
            <a:ext cx="5587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3618442"/>
            <a:ext cx="5587602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2428347"/>
            <a:ext cx="5615120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3618442"/>
            <a:ext cx="5615120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082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60382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43851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1426283"/>
            <a:ext cx="6686550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127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1426283"/>
            <a:ext cx="6686550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70735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37126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527403"/>
            <a:ext cx="2847975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527403"/>
            <a:ext cx="8378825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43131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Text Placeholder 7"/>
          <p:cNvSpPr>
            <a:spLocks noGrp="1"/>
          </p:cNvSpPr>
          <p:nvPr>
            <p:ph type="body" sz="quarter" idx="10" hasCustomPrompt="1"/>
          </p:nvPr>
        </p:nvSpPr>
        <p:spPr>
          <a:xfrm>
            <a:off x="2" y="8634118"/>
            <a:ext cx="10396988" cy="797372"/>
          </a:xfrm>
        </p:spPr>
        <p:txBody>
          <a:bodyPr anchor="b" anchorCtr="0">
            <a:normAutofit/>
          </a:bodyPr>
          <a:lstStyle>
            <a:lvl1pPr marL="0" indent="0">
              <a:lnSpc>
                <a:spcPct val="95000"/>
              </a:lnSpc>
              <a:spcBef>
                <a:spcPts val="0"/>
              </a:spcBef>
              <a:buNone/>
              <a:defRPr sz="2226">
                <a:solidFill>
                  <a:schemeClr val="tx1"/>
                </a:solidFill>
              </a:defRPr>
            </a:lvl1pPr>
            <a:lvl2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2pPr>
            <a:lvl3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3pPr>
            <a:lvl4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4pPr>
            <a:lvl5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5pPr>
          </a:lstStyle>
          <a:p>
            <a:pPr lvl="0"/>
            <a:r>
              <a:rPr lang="en-US" dirty="0"/>
              <a:t>Sources</a:t>
            </a:r>
          </a:p>
        </p:txBody>
      </p:sp>
    </p:spTree>
    <p:extLst>
      <p:ext uri="{BB962C8B-B14F-4D97-AF65-F5344CB8AC3E}">
        <p14:creationId xmlns:p14="http://schemas.microsoft.com/office/powerpoint/2010/main" val="3016529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ection 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2527458"/>
            <a:ext cx="13208000" cy="6934990"/>
          </a:xfrm>
          <a:prstGeom prst="rect">
            <a:avLst/>
          </a:prstGeom>
          <a:solidFill>
            <a:schemeClr val="bg1"/>
          </a:solidFill>
          <a:ln w="12700" cmpd="sng"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>
              <a:lnSpc>
                <a:spcPct val="95000"/>
              </a:lnSpc>
              <a:spcAft>
                <a:spcPts val="2226"/>
              </a:spcAft>
              <a:buClr>
                <a:srgbClr val="969696"/>
              </a:buClr>
              <a:buSzPct val="80000"/>
              <a:tabLst>
                <a:tab pos="1006862" algn="r"/>
                <a:tab pos="2994089" algn="r"/>
                <a:tab pos="4981315" algn="r"/>
                <a:tab pos="6995038" algn="r"/>
                <a:tab pos="8982265" algn="r"/>
                <a:tab pos="10969493" algn="r"/>
                <a:tab pos="12983216" algn="r"/>
                <a:tab pos="14970442" algn="r"/>
                <a:tab pos="16957669" algn="r"/>
                <a:tab pos="18971394" algn="r"/>
                <a:tab pos="20958620" algn="r"/>
              </a:tabLst>
            </a:pPr>
            <a:endParaRPr lang="en-US" sz="3894" noProof="1">
              <a:solidFill>
                <a:schemeClr val="tx1"/>
              </a:solidFill>
              <a:latin typeface="Calibri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60400" y="5239554"/>
            <a:ext cx="11887200" cy="710818"/>
          </a:xfrm>
        </p:spPr>
        <p:txBody>
          <a:bodyPr anchor="b" anchorCtr="0">
            <a:normAutofit/>
          </a:bodyPr>
          <a:lstStyle>
            <a:lvl1pPr>
              <a:defRPr sz="10015">
                <a:solidFill>
                  <a:srgbClr val="FF543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60400" y="6228257"/>
            <a:ext cx="9245600" cy="1321235"/>
          </a:xfrm>
        </p:spPr>
        <p:txBody>
          <a:bodyPr/>
          <a:lstStyle>
            <a:lvl1pPr marL="0" indent="0" algn="l">
              <a:buNone/>
              <a:defRPr b="1">
                <a:solidFill>
                  <a:srgbClr val="CEC4BE"/>
                </a:solidFill>
              </a:defRPr>
            </a:lvl1pPr>
            <a:lvl2pPr marL="12718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5436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8154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0873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3591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6309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89027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01746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pic>
        <p:nvPicPr>
          <p:cNvPr id="6" name="Picture 5" descr="Arsanis_logo_LARGE.pn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16785" y="595569"/>
            <a:ext cx="1930816" cy="606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7523116"/>
      </p:ext>
    </p:extLst>
  </p:cSld>
  <p:clrMapOvr>
    <a:masterClrMapping/>
  </p:clrMapOvr>
  <p:extLst mod="1">
    <p:ext uri="{DCECCB84-F9BA-43D5-87BE-67443E8EF086}">
      <p15:sldGuideLst xmlns:p15="http://schemas.microsoft.com/office/powerpoint/2012/main">
        <p15:guide id="1" orient="horz" pos="2877" userDrawn="1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5303" y="1589855"/>
            <a:ext cx="12052300" cy="70075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Text Placeholder 7"/>
          <p:cNvSpPr>
            <a:spLocks noGrp="1"/>
          </p:cNvSpPr>
          <p:nvPr>
            <p:ph type="body" sz="quarter" idx="10" hasCustomPrompt="1"/>
          </p:nvPr>
        </p:nvSpPr>
        <p:spPr>
          <a:xfrm>
            <a:off x="2" y="8634118"/>
            <a:ext cx="10396988" cy="797372"/>
          </a:xfrm>
        </p:spPr>
        <p:txBody>
          <a:bodyPr anchor="b" anchorCtr="0">
            <a:normAutofit/>
          </a:bodyPr>
          <a:lstStyle>
            <a:lvl1pPr marL="0" indent="0">
              <a:lnSpc>
                <a:spcPct val="95000"/>
              </a:lnSpc>
              <a:spcBef>
                <a:spcPts val="0"/>
              </a:spcBef>
              <a:buNone/>
              <a:defRPr sz="2226">
                <a:solidFill>
                  <a:schemeClr val="tx1"/>
                </a:solidFill>
              </a:defRPr>
            </a:lvl1pPr>
            <a:lvl2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2pPr>
            <a:lvl3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3pPr>
            <a:lvl4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4pPr>
            <a:lvl5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5pPr>
          </a:lstStyle>
          <a:p>
            <a:pPr lvl="0"/>
            <a:r>
              <a:rPr lang="en-US" dirty="0"/>
              <a:t>Sources</a:t>
            </a:r>
          </a:p>
        </p:txBody>
      </p:sp>
    </p:spTree>
    <p:extLst>
      <p:ext uri="{BB962C8B-B14F-4D97-AF65-F5344CB8AC3E}">
        <p14:creationId xmlns:p14="http://schemas.microsoft.com/office/powerpoint/2010/main" val="145059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Text Placeholder 7"/>
          <p:cNvSpPr>
            <a:spLocks noGrp="1"/>
          </p:cNvSpPr>
          <p:nvPr>
            <p:ph type="body" sz="quarter" idx="10" hasCustomPrompt="1"/>
          </p:nvPr>
        </p:nvSpPr>
        <p:spPr>
          <a:xfrm>
            <a:off x="2" y="8634118"/>
            <a:ext cx="10396988" cy="797372"/>
          </a:xfrm>
        </p:spPr>
        <p:txBody>
          <a:bodyPr anchor="b" anchorCtr="0">
            <a:normAutofit/>
          </a:bodyPr>
          <a:lstStyle>
            <a:lvl1pPr marL="0" indent="0">
              <a:lnSpc>
                <a:spcPct val="95000"/>
              </a:lnSpc>
              <a:spcBef>
                <a:spcPts val="0"/>
              </a:spcBef>
              <a:buNone/>
              <a:defRPr sz="2226">
                <a:solidFill>
                  <a:schemeClr val="tx1"/>
                </a:solidFill>
              </a:defRPr>
            </a:lvl1pPr>
            <a:lvl2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2pPr>
            <a:lvl3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3pPr>
            <a:lvl4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4pPr>
            <a:lvl5pPr marL="0" indent="0">
              <a:lnSpc>
                <a:spcPct val="95000"/>
              </a:lnSpc>
              <a:spcBef>
                <a:spcPts val="0"/>
              </a:spcBef>
              <a:buNone/>
              <a:defRPr sz="2504">
                <a:solidFill>
                  <a:schemeClr val="tx1"/>
                </a:solidFill>
              </a:defRPr>
            </a:lvl5pPr>
          </a:lstStyle>
          <a:p>
            <a:pPr lvl="0"/>
            <a:r>
              <a:rPr lang="en-US" dirty="0"/>
              <a:t>Sources</a:t>
            </a:r>
          </a:p>
        </p:txBody>
      </p:sp>
    </p:spTree>
    <p:extLst>
      <p:ext uri="{BB962C8B-B14F-4D97-AF65-F5344CB8AC3E}">
        <p14:creationId xmlns:p14="http://schemas.microsoft.com/office/powerpoint/2010/main" val="3932223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32359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1621191"/>
            <a:ext cx="112268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5202944"/>
            <a:ext cx="99060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150734F-3735-49AA-8EF4-49C048FABBD3}"/>
              </a:ext>
            </a:extLst>
          </p:cNvPr>
          <p:cNvSpPr/>
          <p:nvPr userDrawn="1"/>
        </p:nvSpPr>
        <p:spPr>
          <a:xfrm>
            <a:off x="0" y="2527458"/>
            <a:ext cx="13208000" cy="6934990"/>
          </a:xfrm>
          <a:prstGeom prst="rect">
            <a:avLst/>
          </a:prstGeom>
          <a:solidFill>
            <a:schemeClr val="bg1"/>
          </a:solidFill>
          <a:ln w="12700" cmpd="sng"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>
              <a:lnSpc>
                <a:spcPct val="95000"/>
              </a:lnSpc>
              <a:spcAft>
                <a:spcPts val="2226"/>
              </a:spcAft>
              <a:buClr>
                <a:srgbClr val="969696"/>
              </a:buClr>
              <a:buSzPct val="80000"/>
              <a:tabLst>
                <a:tab pos="1006862" algn="r"/>
                <a:tab pos="2994089" algn="r"/>
                <a:tab pos="4981315" algn="r"/>
                <a:tab pos="6995038" algn="r"/>
                <a:tab pos="8982265" algn="r"/>
                <a:tab pos="10969493" algn="r"/>
                <a:tab pos="12983216" algn="r"/>
                <a:tab pos="14970442" algn="r"/>
                <a:tab pos="16957669" algn="r"/>
                <a:tab pos="18971394" algn="r"/>
                <a:tab pos="20958620" algn="r"/>
              </a:tabLst>
            </a:pPr>
            <a:endParaRPr lang="en-US" sz="3894" noProof="1">
              <a:solidFill>
                <a:schemeClr val="tx1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686028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877" userDrawn="1">
          <p15:clr>
            <a:srgbClr val="FBAE40"/>
          </p15:clr>
        </p15:guide>
      </p15:sldGuideLst>
    </p:ext>
  </p:extLs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176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2469624"/>
            <a:ext cx="11391900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6629226"/>
            <a:ext cx="11391900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837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2637014"/>
            <a:ext cx="561340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2637014"/>
            <a:ext cx="561340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BC23B-3AC3-43D9-981D-EF5B111F3711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59FC5-F04F-4720-802E-E60911006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440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3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8.xml"/><Relationship Id="rId7" Type="http://schemas.openxmlformats.org/officeDocument/2006/relationships/slideLayout" Target="../slideLayouts/slideLayout12.xml"/><Relationship Id="rId12" Type="http://schemas.openxmlformats.org/officeDocument/2006/relationships/slideLayout" Target="../slideLayouts/slideLayout17.xml"/><Relationship Id="rId2" Type="http://schemas.openxmlformats.org/officeDocument/2006/relationships/slideLayout" Target="../slideLayouts/slideLayout7.xml"/><Relationship Id="rId1" Type="http://schemas.openxmlformats.org/officeDocument/2006/relationships/slideLayout" Target="../slideLayouts/slideLayout6.xml"/><Relationship Id="rId6" Type="http://schemas.openxmlformats.org/officeDocument/2006/relationships/slideLayout" Target="../slideLayouts/slideLayout11.xml"/><Relationship Id="rId11" Type="http://schemas.openxmlformats.org/officeDocument/2006/relationships/slideLayout" Target="../slideLayouts/slideLayout16.xml"/><Relationship Id="rId5" Type="http://schemas.openxmlformats.org/officeDocument/2006/relationships/slideLayout" Target="../slideLayouts/slideLayout10.xml"/><Relationship Id="rId10" Type="http://schemas.openxmlformats.org/officeDocument/2006/relationships/slideLayout" Target="../slideLayouts/slideLayout15.xml"/><Relationship Id="rId4" Type="http://schemas.openxmlformats.org/officeDocument/2006/relationships/slideLayout" Target="../slideLayouts/slideLayout9.xml"/><Relationship Id="rId9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7528" y="174887"/>
            <a:ext cx="12260206" cy="1186275"/>
          </a:xfrm>
          <a:prstGeom prst="rect">
            <a:avLst/>
          </a:prstGeom>
        </p:spPr>
        <p:txBody>
          <a:bodyPr vert="horz" lIns="91440" tIns="45720" rIns="91440" bIns="45720" rtlCol="0" anchor="b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5" y="1589855"/>
            <a:ext cx="12137907" cy="71543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pic>
        <p:nvPicPr>
          <p:cNvPr id="8" name="Picture 7" descr="Arsanis_logo_LARGE.png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00334" y="8656486"/>
            <a:ext cx="1930816" cy="634981"/>
          </a:xfrm>
          <a:prstGeom prst="rect">
            <a:avLst/>
          </a:prstGeom>
        </p:spPr>
      </p:pic>
      <p:cxnSp>
        <p:nvCxnSpPr>
          <p:cNvPr id="9" name="Straight Connector 8"/>
          <p:cNvCxnSpPr/>
          <p:nvPr/>
        </p:nvCxnSpPr>
        <p:spPr>
          <a:xfrm flipV="1">
            <a:off x="571402" y="1407927"/>
            <a:ext cx="1208382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Process 11"/>
          <p:cNvSpPr/>
          <p:nvPr/>
        </p:nvSpPr>
        <p:spPr>
          <a:xfrm>
            <a:off x="0" y="9465736"/>
            <a:ext cx="13221208" cy="449439"/>
          </a:xfrm>
          <a:prstGeom prst="flowChartProcess">
            <a:avLst/>
          </a:prstGeom>
          <a:solidFill>
            <a:srgbClr val="635D5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5007" dirty="0">
              <a:solidFill>
                <a:schemeClr val="tx1"/>
              </a:solidFill>
              <a:latin typeface="Calibri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72406" y="9501307"/>
            <a:ext cx="6856877" cy="606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indent="0" algn="l" defTabSz="25436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3338" dirty="0">
                <a:solidFill>
                  <a:schemeClr val="bg1"/>
                </a:solidFill>
                <a:latin typeface="Calibri"/>
              </a:rPr>
              <a:t>Arsanis, Inc.  2018.  All rights reserved.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2009499" y="9501306"/>
            <a:ext cx="687958" cy="60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indent="0" algn="r" defTabSz="25436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28DD380-A8F5-5441-A2AC-8F10E9B3514D}" type="slidenum">
              <a:rPr lang="en-US" sz="3338" smtClean="0">
                <a:solidFill>
                  <a:schemeClr val="bg1"/>
                </a:solidFill>
                <a:latin typeface="Calibri"/>
              </a:rPr>
              <a:pPr marL="0" marR="0" indent="0" algn="r" defTabSz="254365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lang="en-US" sz="3338" dirty="0">
              <a:solidFill>
                <a:schemeClr val="bg1"/>
              </a:solidFill>
              <a:latin typeface="Calibri"/>
            </a:endParaRPr>
          </a:p>
        </p:txBody>
      </p:sp>
      <p:sp>
        <p:nvSpPr>
          <p:cNvPr id="10" name="TextBox 9"/>
          <p:cNvSpPr txBox="1"/>
          <p:nvPr userDrawn="1"/>
        </p:nvSpPr>
        <p:spPr>
          <a:xfrm>
            <a:off x="5228943" y="9501307"/>
            <a:ext cx="2763321" cy="606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indent="0" algn="ctr" defTabSz="25436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3338" dirty="0">
                <a:solidFill>
                  <a:schemeClr val="bg1"/>
                </a:solidFill>
                <a:latin typeface="Calibri"/>
              </a:rPr>
              <a:t>CONFIDENTIAL</a:t>
            </a:r>
          </a:p>
        </p:txBody>
      </p:sp>
    </p:spTree>
    <p:extLst>
      <p:ext uri="{BB962C8B-B14F-4D97-AF65-F5344CB8AC3E}">
        <p14:creationId xmlns:p14="http://schemas.microsoft.com/office/powerpoint/2010/main" val="2227966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2" r:id="rId1"/>
    <p:sldLayoutId id="2147483836" r:id="rId2"/>
    <p:sldLayoutId id="2147483810" r:id="rId3"/>
    <p:sldLayoutId id="2147483814" r:id="rId4"/>
    <p:sldLayoutId id="2147483815" r:id="rId5"/>
  </p:sldLayoutIdLst>
  <p:txStyles>
    <p:titleStyle>
      <a:lvl1pPr algn="l" defTabSz="1271826" rtl="0" eaLnBrk="1" latinLnBrk="0" hangingPunct="1">
        <a:spcBef>
          <a:spcPct val="0"/>
        </a:spcBef>
        <a:buNone/>
        <a:defRPr sz="6398" b="1" kern="1200">
          <a:solidFill>
            <a:schemeClr val="accent2"/>
          </a:solidFill>
          <a:latin typeface="+mj-lt"/>
          <a:ea typeface="+mj-ea"/>
          <a:cs typeface="+mj-cs"/>
        </a:defRPr>
      </a:lvl1pPr>
    </p:titleStyle>
    <p:bodyStyle>
      <a:lvl1pPr marL="635913" indent="-635913" algn="l" defTabSz="1271826" rtl="0" eaLnBrk="1" latinLnBrk="0" hangingPunct="1">
        <a:spcBef>
          <a:spcPts val="2504"/>
        </a:spcBef>
        <a:buClr>
          <a:schemeClr val="accent2"/>
        </a:buClr>
        <a:buFont typeface="Arial"/>
        <a:buChar char="•"/>
        <a:defRPr sz="5564" kern="1200">
          <a:solidFill>
            <a:schemeClr val="tx1"/>
          </a:solidFill>
          <a:latin typeface="+mn-lt"/>
          <a:ea typeface="+mn-ea"/>
          <a:cs typeface="+mn-cs"/>
        </a:defRPr>
      </a:lvl1pPr>
      <a:lvl2pPr marL="1603031" indent="-640331" algn="l" defTabSz="1271826" rtl="0" eaLnBrk="1" latinLnBrk="0" hangingPunct="1">
        <a:spcBef>
          <a:spcPts val="1670"/>
        </a:spcBef>
        <a:buClr>
          <a:schemeClr val="accent2"/>
        </a:buClr>
        <a:buFont typeface="Arial"/>
        <a:buChar char="–"/>
        <a:tabLst/>
        <a:defRPr sz="5007" kern="1200">
          <a:solidFill>
            <a:schemeClr val="tx1"/>
          </a:solidFill>
          <a:latin typeface="+mn-lt"/>
          <a:ea typeface="+mn-ea"/>
          <a:cs typeface="+mn-cs"/>
        </a:defRPr>
      </a:lvl2pPr>
      <a:lvl3pPr marL="2238943" indent="-494598" algn="l" defTabSz="1271826" rtl="0" eaLnBrk="1" latinLnBrk="0" hangingPunct="1">
        <a:spcBef>
          <a:spcPts val="1670"/>
        </a:spcBef>
        <a:buClr>
          <a:schemeClr val="accent2"/>
        </a:buClr>
        <a:buFont typeface="Arial"/>
        <a:buChar char="•"/>
        <a:defRPr sz="4451" kern="1200">
          <a:solidFill>
            <a:schemeClr val="tx1"/>
          </a:solidFill>
          <a:latin typeface="+mn-lt"/>
          <a:ea typeface="+mn-ea"/>
          <a:cs typeface="+mn-cs"/>
        </a:defRPr>
      </a:lvl3pPr>
      <a:lvl4pPr marL="2852774" indent="-476934" algn="l" defTabSz="1271826" rtl="0" eaLnBrk="1" latinLnBrk="0" hangingPunct="1">
        <a:spcBef>
          <a:spcPts val="834"/>
        </a:spcBef>
        <a:buClr>
          <a:schemeClr val="accent2"/>
        </a:buClr>
        <a:buFont typeface="Arial"/>
        <a:buChar char="–"/>
        <a:defRPr sz="3894" kern="1200">
          <a:solidFill>
            <a:schemeClr val="tx1"/>
          </a:solidFill>
          <a:latin typeface="+mn-lt"/>
          <a:ea typeface="+mn-ea"/>
          <a:cs typeface="+mn-cs"/>
        </a:defRPr>
      </a:lvl4pPr>
      <a:lvl5pPr marL="3510769" indent="-485766" algn="l" defTabSz="1271826" rtl="0" eaLnBrk="1" latinLnBrk="0" hangingPunct="1">
        <a:spcBef>
          <a:spcPts val="834"/>
        </a:spcBef>
        <a:buClr>
          <a:schemeClr val="accent2"/>
        </a:buClr>
        <a:buFont typeface="Arial"/>
        <a:buChar char="»"/>
        <a:tabLst/>
        <a:defRPr sz="3894" kern="1200">
          <a:solidFill>
            <a:schemeClr val="tx1"/>
          </a:solidFill>
          <a:latin typeface="+mn-lt"/>
          <a:ea typeface="+mn-ea"/>
          <a:cs typeface="+mn-cs"/>
        </a:defRPr>
      </a:lvl5pPr>
      <a:lvl6pPr marL="6995038" indent="-635913" algn="l" defTabSz="1271826" rtl="0" eaLnBrk="1" latinLnBrk="0" hangingPunct="1">
        <a:spcBef>
          <a:spcPct val="20000"/>
        </a:spcBef>
        <a:buFont typeface="Arial"/>
        <a:buChar char="•"/>
        <a:defRPr sz="5564" kern="1200">
          <a:solidFill>
            <a:schemeClr val="tx1"/>
          </a:solidFill>
          <a:latin typeface="+mn-lt"/>
          <a:ea typeface="+mn-ea"/>
          <a:cs typeface="+mn-cs"/>
        </a:defRPr>
      </a:lvl6pPr>
      <a:lvl7pPr marL="8266864" indent="-635913" algn="l" defTabSz="1271826" rtl="0" eaLnBrk="1" latinLnBrk="0" hangingPunct="1">
        <a:spcBef>
          <a:spcPct val="20000"/>
        </a:spcBef>
        <a:buFont typeface="Arial"/>
        <a:buChar char="•"/>
        <a:defRPr sz="5564" kern="1200">
          <a:solidFill>
            <a:schemeClr val="tx1"/>
          </a:solidFill>
          <a:latin typeface="+mn-lt"/>
          <a:ea typeface="+mn-ea"/>
          <a:cs typeface="+mn-cs"/>
        </a:defRPr>
      </a:lvl7pPr>
      <a:lvl8pPr marL="9538690" indent="-635913" algn="l" defTabSz="1271826" rtl="0" eaLnBrk="1" latinLnBrk="0" hangingPunct="1">
        <a:spcBef>
          <a:spcPct val="20000"/>
        </a:spcBef>
        <a:buFont typeface="Arial"/>
        <a:buChar char="•"/>
        <a:defRPr sz="5564" kern="1200">
          <a:solidFill>
            <a:schemeClr val="tx1"/>
          </a:solidFill>
          <a:latin typeface="+mn-lt"/>
          <a:ea typeface="+mn-ea"/>
          <a:cs typeface="+mn-cs"/>
        </a:defRPr>
      </a:lvl8pPr>
      <a:lvl9pPr marL="10810514" indent="-635913" algn="l" defTabSz="1271826" rtl="0" eaLnBrk="1" latinLnBrk="0" hangingPunct="1">
        <a:spcBef>
          <a:spcPct val="20000"/>
        </a:spcBef>
        <a:buFont typeface="Arial"/>
        <a:buChar char="•"/>
        <a:defRPr sz="556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71826" rtl="0" eaLnBrk="1" latinLnBrk="0" hangingPunct="1">
        <a:defRPr sz="5007" kern="1200">
          <a:solidFill>
            <a:schemeClr val="tx1"/>
          </a:solidFill>
          <a:latin typeface="+mn-lt"/>
          <a:ea typeface="+mn-ea"/>
          <a:cs typeface="+mn-cs"/>
        </a:defRPr>
      </a:lvl1pPr>
      <a:lvl2pPr marL="1271826" algn="l" defTabSz="1271826" rtl="0" eaLnBrk="1" latinLnBrk="0" hangingPunct="1">
        <a:defRPr sz="5007" kern="1200">
          <a:solidFill>
            <a:schemeClr val="tx1"/>
          </a:solidFill>
          <a:latin typeface="+mn-lt"/>
          <a:ea typeface="+mn-ea"/>
          <a:cs typeface="+mn-cs"/>
        </a:defRPr>
      </a:lvl2pPr>
      <a:lvl3pPr marL="2543650" algn="l" defTabSz="1271826" rtl="0" eaLnBrk="1" latinLnBrk="0" hangingPunct="1">
        <a:defRPr sz="5007" kern="1200">
          <a:solidFill>
            <a:schemeClr val="tx1"/>
          </a:solidFill>
          <a:latin typeface="+mn-lt"/>
          <a:ea typeface="+mn-ea"/>
          <a:cs typeface="+mn-cs"/>
        </a:defRPr>
      </a:lvl3pPr>
      <a:lvl4pPr marL="3815476" algn="l" defTabSz="1271826" rtl="0" eaLnBrk="1" latinLnBrk="0" hangingPunct="1">
        <a:defRPr sz="5007" kern="1200">
          <a:solidFill>
            <a:schemeClr val="tx1"/>
          </a:solidFill>
          <a:latin typeface="+mn-lt"/>
          <a:ea typeface="+mn-ea"/>
          <a:cs typeface="+mn-cs"/>
        </a:defRPr>
      </a:lvl4pPr>
      <a:lvl5pPr marL="5087301" algn="l" defTabSz="1271826" rtl="0" eaLnBrk="1" latinLnBrk="0" hangingPunct="1">
        <a:defRPr sz="5007" kern="1200">
          <a:solidFill>
            <a:schemeClr val="tx1"/>
          </a:solidFill>
          <a:latin typeface="+mn-lt"/>
          <a:ea typeface="+mn-ea"/>
          <a:cs typeface="+mn-cs"/>
        </a:defRPr>
      </a:lvl5pPr>
      <a:lvl6pPr marL="6359125" algn="l" defTabSz="1271826" rtl="0" eaLnBrk="1" latinLnBrk="0" hangingPunct="1">
        <a:defRPr sz="5007" kern="1200">
          <a:solidFill>
            <a:schemeClr val="tx1"/>
          </a:solidFill>
          <a:latin typeface="+mn-lt"/>
          <a:ea typeface="+mn-ea"/>
          <a:cs typeface="+mn-cs"/>
        </a:defRPr>
      </a:lvl6pPr>
      <a:lvl7pPr marL="7630951" algn="l" defTabSz="1271826" rtl="0" eaLnBrk="1" latinLnBrk="0" hangingPunct="1">
        <a:defRPr sz="5007" kern="1200">
          <a:solidFill>
            <a:schemeClr val="tx1"/>
          </a:solidFill>
          <a:latin typeface="+mn-lt"/>
          <a:ea typeface="+mn-ea"/>
          <a:cs typeface="+mn-cs"/>
        </a:defRPr>
      </a:lvl7pPr>
      <a:lvl8pPr marL="8902777" algn="l" defTabSz="1271826" rtl="0" eaLnBrk="1" latinLnBrk="0" hangingPunct="1">
        <a:defRPr sz="5007" kern="1200">
          <a:solidFill>
            <a:schemeClr val="tx1"/>
          </a:solidFill>
          <a:latin typeface="+mn-lt"/>
          <a:ea typeface="+mn-ea"/>
          <a:cs typeface="+mn-cs"/>
        </a:defRPr>
      </a:lvl8pPr>
      <a:lvl9pPr marL="10174601" algn="l" defTabSz="1271826" rtl="0" eaLnBrk="1" latinLnBrk="0" hangingPunct="1">
        <a:defRPr sz="500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527405"/>
            <a:ext cx="1139190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2637014"/>
            <a:ext cx="1139190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8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9181397"/>
            <a:ext cx="4457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AFFC379-F4B7-443C-9CFF-88EEDF99E9FF}"/>
              </a:ext>
            </a:extLst>
          </p:cNvPr>
          <p:cNvSpPr txBox="1"/>
          <p:nvPr userDrawn="1"/>
        </p:nvSpPr>
        <p:spPr>
          <a:xfrm>
            <a:off x="5228943" y="9501307"/>
            <a:ext cx="2763321" cy="606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indent="0" algn="ctr" defTabSz="25436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3338" dirty="0">
                <a:solidFill>
                  <a:schemeClr val="bg1"/>
                </a:solidFill>
                <a:latin typeface="Calibri"/>
              </a:rPr>
              <a:t>CONFIDENTIAL</a:t>
            </a:r>
          </a:p>
        </p:txBody>
      </p:sp>
    </p:spTree>
    <p:extLst>
      <p:ext uri="{BB962C8B-B14F-4D97-AF65-F5344CB8AC3E}">
        <p14:creationId xmlns:p14="http://schemas.microsoft.com/office/powerpoint/2010/main" val="56952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74" r:id="rId1"/>
    <p:sldLayoutId id="2147483875" r:id="rId2"/>
    <p:sldLayoutId id="2147483876" r:id="rId3"/>
    <p:sldLayoutId id="2147483877" r:id="rId4"/>
    <p:sldLayoutId id="2147483878" r:id="rId5"/>
    <p:sldLayoutId id="2147483879" r:id="rId6"/>
    <p:sldLayoutId id="2147483880" r:id="rId7"/>
    <p:sldLayoutId id="2147483881" r:id="rId8"/>
    <p:sldLayoutId id="2147483882" r:id="rId9"/>
    <p:sldLayoutId id="2147483883" r:id="rId10"/>
    <p:sldLayoutId id="2147483884" r:id="rId11"/>
    <p:sldLayoutId id="2147483885" r:id="rId12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1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7.emf"/><Relationship Id="rId4" Type="http://schemas.openxmlformats.org/officeDocument/2006/relationships/oleObject" Target="../embeddings/oleObject3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17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8.emf"/><Relationship Id="rId4" Type="http://schemas.openxmlformats.org/officeDocument/2006/relationships/oleObject" Target="../embeddings/oleObject4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767764" y="1694271"/>
            <a:ext cx="958659" cy="3886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926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92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93919" y="345112"/>
            <a:ext cx="5625628" cy="62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3467" dirty="0"/>
              <a:t>Suppl</a:t>
            </a:r>
            <a:r>
              <a:rPr lang="de-AT" sz="3467" dirty="0"/>
              <a:t>ementary</a:t>
            </a:r>
            <a:r>
              <a:rPr lang="hu-HU" sz="3467" dirty="0"/>
              <a:t> Fig</a:t>
            </a:r>
            <a:r>
              <a:rPr lang="de-AT" sz="3467" dirty="0"/>
              <a:t>ure</a:t>
            </a:r>
            <a:r>
              <a:rPr lang="hu-HU" sz="3467" dirty="0"/>
              <a:t> 1</a:t>
            </a:r>
            <a:endParaRPr lang="en-US" sz="3467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00653FA-ED72-4115-9241-E3C5FBAF346E}"/>
              </a:ext>
            </a:extLst>
          </p:cNvPr>
          <p:cNvSpPr txBox="1"/>
          <p:nvPr/>
        </p:nvSpPr>
        <p:spPr>
          <a:xfrm>
            <a:off x="6589497" y="1696821"/>
            <a:ext cx="958659" cy="3886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926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92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ontent Placeholder 17"/>
          <p:cNvSpPr>
            <a:spLocks noGrp="1"/>
          </p:cNvSpPr>
          <p:nvPr>
            <p:ph idx="1"/>
          </p:nvPr>
        </p:nvSpPr>
        <p:spPr>
          <a:xfrm>
            <a:off x="908050" y="5871480"/>
            <a:ext cx="11391900" cy="3165099"/>
          </a:xfrm>
        </p:spPr>
        <p:txBody>
          <a:bodyPr>
            <a:normAutofit fontScale="47500" lnSpcReduction="20000"/>
          </a:bodyPr>
          <a:lstStyle/>
          <a:p>
            <a:pPr marL="0" marR="0" indent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4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Depletion of C1q and MBL2 by k/l -specific resin. </a:t>
            </a:r>
            <a:r>
              <a:rPr lang="en-US" sz="4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LISA was performed to detect MBL2 </a:t>
            </a:r>
            <a:r>
              <a:rPr lang="en-US" sz="44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4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C1q </a:t>
            </a:r>
            <a:r>
              <a:rPr lang="en-US" sz="44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4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sera depleted by light-chain specific resin (Ig-dep), in mock treated sera (mock) or in the eluted fraction (E). Graph shows mean values obtained with sera from 4 donors ±SEM. C1q and MBL2 levels in Ig-dep were compared to that in the mock treated sample by two-tailed paired t-test (*P&lt; 0.05). The circle, square, triangle and diamond represent donor #3, #5, #12 and #25 respectively.</a:t>
            </a:r>
            <a:r>
              <a:rPr lang="en-US" sz="4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4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detection limit is indicated by the dotted line.</a:t>
            </a:r>
            <a:endParaRPr lang="en-GB" sz="4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0B7A4029-4DF6-4A38-983C-AFBBF0EB31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7284105"/>
              </p:ext>
            </p:extLst>
          </p:nvPr>
        </p:nvGraphicFramePr>
        <p:xfrm>
          <a:off x="1052513" y="1985963"/>
          <a:ext cx="5664200" cy="3243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4" name="Prism 6" r:id="rId4" imgW="4358723" imgH="2495867" progId="Prism6.Document">
                  <p:embed/>
                </p:oleObj>
              </mc:Choice>
              <mc:Fallback>
                <p:oleObj name="Prism 6" r:id="rId4" imgW="4358723" imgH="2495867" progId="Prism6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70ED3ADF-F54F-4639-A3A5-56476072A5E4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52513" y="1985963"/>
                        <a:ext cx="5664200" cy="324326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951B2333-22F2-4E38-9083-A2AB8298B1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490464"/>
              </p:ext>
            </p:extLst>
          </p:nvPr>
        </p:nvGraphicFramePr>
        <p:xfrm>
          <a:off x="6645690" y="1978559"/>
          <a:ext cx="5836756" cy="32446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5" name="Prism 6" r:id="rId6" imgW="4489812" imgH="2495867" progId="Prism6.Document">
                  <p:embed/>
                </p:oleObj>
              </mc:Choice>
              <mc:Fallback>
                <p:oleObj name="Prism 6" r:id="rId6" imgW="4489812" imgH="2495867" progId="Prism6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1F73D896-97B6-45BA-9F2F-94DB083C2FE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645690" y="1978559"/>
                        <a:ext cx="5836756" cy="324462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719984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04805" y="424039"/>
            <a:ext cx="5209820" cy="62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3467" dirty="0"/>
              <a:t>Suppl</a:t>
            </a:r>
            <a:r>
              <a:rPr lang="de-AT" sz="3467" dirty="0"/>
              <a:t>ementary</a:t>
            </a:r>
            <a:r>
              <a:rPr lang="hu-HU" sz="3467" dirty="0"/>
              <a:t> Fi</a:t>
            </a:r>
            <a:r>
              <a:rPr lang="de-AT" sz="3467" dirty="0"/>
              <a:t>gure 2</a:t>
            </a:r>
            <a:endParaRPr lang="en-US" sz="3467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EA1BD12-C880-4E25-B925-DD29368E36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4181" y="961103"/>
            <a:ext cx="7119638" cy="498593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B6000172-D9D3-48E8-8A8C-A2CDB8C30D3D}"/>
              </a:ext>
            </a:extLst>
          </p:cNvPr>
          <p:cNvSpPr/>
          <p:nvPr/>
        </p:nvSpPr>
        <p:spPr>
          <a:xfrm>
            <a:off x="965201" y="5842725"/>
            <a:ext cx="11277600" cy="19795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2. Rabbit erythrocyte lysis by the reconstituted alternative pathway. 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he activity of the reconstituted alternative pathway with all factors (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P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or without C5 (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P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w/o C5) was measured by rabbit erythrocyte 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aemolysis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ssay. NHS was used as positive control. Graph show results of one representative experiment.</a:t>
            </a:r>
            <a:endParaRPr lang="en-GB" sz="2100" dirty="0"/>
          </a:p>
        </p:txBody>
      </p:sp>
    </p:spTree>
    <p:extLst>
      <p:ext uri="{BB962C8B-B14F-4D97-AF65-F5344CB8AC3E}">
        <p14:creationId xmlns:p14="http://schemas.microsoft.com/office/powerpoint/2010/main" val="12647509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F07D5CE-4BFB-4011-88B2-BCD205CF81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392" t="15368"/>
          <a:stretch/>
        </p:blipFill>
        <p:spPr>
          <a:xfrm>
            <a:off x="4419422" y="2972933"/>
            <a:ext cx="3940146" cy="248958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42905" y="443089"/>
            <a:ext cx="5209820" cy="62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3467" dirty="0"/>
              <a:t>Suppl</a:t>
            </a:r>
            <a:r>
              <a:rPr lang="de-AT" sz="3467" dirty="0"/>
              <a:t>ementary</a:t>
            </a:r>
            <a:r>
              <a:rPr lang="hu-HU" sz="3467" dirty="0"/>
              <a:t> Fi</a:t>
            </a:r>
            <a:r>
              <a:rPr lang="de-AT" sz="3467" dirty="0"/>
              <a:t>gure 3</a:t>
            </a:r>
            <a:endParaRPr lang="en-US" sz="3467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07ED739-34D5-411B-B007-ADE18EA9D524}"/>
              </a:ext>
            </a:extLst>
          </p:cNvPr>
          <p:cNvSpPr txBox="1"/>
          <p:nvPr/>
        </p:nvSpPr>
        <p:spPr>
          <a:xfrm>
            <a:off x="8390525" y="2895003"/>
            <a:ext cx="1447000" cy="299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348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it-IT" sz="1348" dirty="0">
                <a:latin typeface="Arial" panose="020B0604020202020204" pitchFamily="34" charset="0"/>
                <a:cs typeface="Arial" panose="020B0604020202020204" pitchFamily="34" charset="0"/>
              </a:rPr>
              <a:t>-chain</a:t>
            </a:r>
            <a:endParaRPr lang="en-US" sz="134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Isosceles Triangle 8">
            <a:extLst>
              <a:ext uri="{FF2B5EF4-FFF2-40B4-BE49-F238E27FC236}">
                <a16:creationId xmlns:a16="http://schemas.microsoft.com/office/drawing/2014/main" id="{939B4489-668C-4EC6-A25B-996AA61EFEA7}"/>
              </a:ext>
            </a:extLst>
          </p:cNvPr>
          <p:cNvSpPr>
            <a:spLocks/>
          </p:cNvSpPr>
          <p:nvPr/>
        </p:nvSpPr>
        <p:spPr>
          <a:xfrm rot="16200000">
            <a:off x="8359431" y="3042981"/>
            <a:ext cx="73291" cy="14788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467"/>
          </a:p>
        </p:txBody>
      </p:sp>
      <p:sp>
        <p:nvSpPr>
          <p:cNvPr id="10" name="Isosceles Triangle 9">
            <a:extLst>
              <a:ext uri="{FF2B5EF4-FFF2-40B4-BE49-F238E27FC236}">
                <a16:creationId xmlns:a16="http://schemas.microsoft.com/office/drawing/2014/main" id="{213D33E3-AC06-4B20-97C5-20CF1AC8D914}"/>
              </a:ext>
            </a:extLst>
          </p:cNvPr>
          <p:cNvSpPr>
            <a:spLocks/>
          </p:cNvSpPr>
          <p:nvPr/>
        </p:nvSpPr>
        <p:spPr>
          <a:xfrm rot="16200000">
            <a:off x="8356767" y="3192410"/>
            <a:ext cx="73291" cy="14788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467"/>
          </a:p>
        </p:txBody>
      </p:sp>
      <p:sp>
        <p:nvSpPr>
          <p:cNvPr id="11" name="Isosceles Triangle 10">
            <a:extLst>
              <a:ext uri="{FF2B5EF4-FFF2-40B4-BE49-F238E27FC236}">
                <a16:creationId xmlns:a16="http://schemas.microsoft.com/office/drawing/2014/main" id="{A0371865-25E0-42EC-8C6F-7BC2FA12597F}"/>
              </a:ext>
            </a:extLst>
          </p:cNvPr>
          <p:cNvSpPr>
            <a:spLocks/>
          </p:cNvSpPr>
          <p:nvPr/>
        </p:nvSpPr>
        <p:spPr>
          <a:xfrm rot="16200000">
            <a:off x="8370112" y="3353816"/>
            <a:ext cx="73291" cy="14788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467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BEFA79-8B59-4FEB-9DF9-CA7F4ECE35AC}"/>
              </a:ext>
            </a:extLst>
          </p:cNvPr>
          <p:cNvSpPr txBox="1"/>
          <p:nvPr/>
        </p:nvSpPr>
        <p:spPr>
          <a:xfrm>
            <a:off x="8372847" y="3058928"/>
            <a:ext cx="1447000" cy="299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348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it-IT" sz="1348" dirty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it-IT" sz="1348" dirty="0">
                <a:latin typeface="Arial" panose="020B0604020202020204" pitchFamily="34" charset="0"/>
                <a:cs typeface="Arial" panose="020B0604020202020204" pitchFamily="34" charset="0"/>
              </a:rPr>
              <a:t>-chain</a:t>
            </a:r>
            <a:endParaRPr lang="en-US" sz="134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BE0A2A1-4498-40E4-BE86-0CAEF3C8336A}"/>
              </a:ext>
            </a:extLst>
          </p:cNvPr>
          <p:cNvSpPr txBox="1"/>
          <p:nvPr/>
        </p:nvSpPr>
        <p:spPr>
          <a:xfrm>
            <a:off x="8378850" y="3215207"/>
            <a:ext cx="1447000" cy="299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348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1348" dirty="0">
                <a:latin typeface="Arial" panose="020B0604020202020204" pitchFamily="34" charset="0"/>
                <a:cs typeface="Arial" panose="020B0604020202020204" pitchFamily="34" charset="0"/>
              </a:rPr>
              <a:t>-chain</a:t>
            </a:r>
            <a:endParaRPr lang="en-US" sz="134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Isosceles Triangle 15">
            <a:extLst>
              <a:ext uri="{FF2B5EF4-FFF2-40B4-BE49-F238E27FC236}">
                <a16:creationId xmlns:a16="http://schemas.microsoft.com/office/drawing/2014/main" id="{C400EA0F-2BA6-4611-8617-F1000793546F}"/>
              </a:ext>
            </a:extLst>
          </p:cNvPr>
          <p:cNvSpPr>
            <a:spLocks/>
          </p:cNvSpPr>
          <p:nvPr/>
        </p:nvSpPr>
        <p:spPr>
          <a:xfrm rot="16200000">
            <a:off x="8376111" y="5125789"/>
            <a:ext cx="73291" cy="14788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467"/>
          </a:p>
        </p:txBody>
      </p:sp>
      <p:sp>
        <p:nvSpPr>
          <p:cNvPr id="17" name="Isosceles Triangle 16">
            <a:extLst>
              <a:ext uri="{FF2B5EF4-FFF2-40B4-BE49-F238E27FC236}">
                <a16:creationId xmlns:a16="http://schemas.microsoft.com/office/drawing/2014/main" id="{C617C317-01D7-4480-ADD8-7D5CEC6CDD07}"/>
              </a:ext>
            </a:extLst>
          </p:cNvPr>
          <p:cNvSpPr>
            <a:spLocks/>
          </p:cNvSpPr>
          <p:nvPr/>
        </p:nvSpPr>
        <p:spPr>
          <a:xfrm rot="16200000">
            <a:off x="8355196" y="4399983"/>
            <a:ext cx="73291" cy="14788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467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9AF447F-DF68-4DAF-B192-E652E889E282}"/>
              </a:ext>
            </a:extLst>
          </p:cNvPr>
          <p:cNvSpPr txBox="1"/>
          <p:nvPr/>
        </p:nvSpPr>
        <p:spPr>
          <a:xfrm>
            <a:off x="8374245" y="4231389"/>
            <a:ext cx="1447000" cy="299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348" dirty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it-IT" sz="1348" dirty="0">
                <a:latin typeface="Arial" panose="020B0604020202020204" pitchFamily="34" charset="0"/>
                <a:cs typeface="Arial" panose="020B0604020202020204" pitchFamily="34" charset="0"/>
              </a:rPr>
              <a:t>-chain</a:t>
            </a:r>
            <a:endParaRPr lang="en-US" sz="134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A5C5173-02D4-4DDC-8A98-AFC7FB622044}"/>
              </a:ext>
            </a:extLst>
          </p:cNvPr>
          <p:cNvSpPr txBox="1"/>
          <p:nvPr/>
        </p:nvSpPr>
        <p:spPr>
          <a:xfrm>
            <a:off x="8403032" y="4962274"/>
            <a:ext cx="1447000" cy="299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348" dirty="0">
                <a:latin typeface="Arial" panose="020B0604020202020204" pitchFamily="34" charset="0"/>
                <a:cs typeface="Arial" panose="020B0604020202020204" pitchFamily="34" charset="0"/>
              </a:rPr>
              <a:t>C4a</a:t>
            </a:r>
            <a:endParaRPr lang="en-US" sz="134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070FF5F-9AA0-455A-BB21-AA4AA3183866}"/>
              </a:ext>
            </a:extLst>
          </p:cNvPr>
          <p:cNvSpPr txBox="1"/>
          <p:nvPr/>
        </p:nvSpPr>
        <p:spPr>
          <a:xfrm>
            <a:off x="4568872" y="2673382"/>
            <a:ext cx="3819173" cy="3294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541" dirty="0">
                <a:latin typeface="Arial" panose="020B0604020202020204" pitchFamily="34" charset="0"/>
                <a:cs typeface="Arial" panose="020B0604020202020204" pitchFamily="34" charset="0"/>
              </a:rPr>
              <a:t>-       0      1      2      3      4       5    10</a:t>
            </a:r>
            <a:endParaRPr lang="en-US" sz="154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4FA8EFF-E303-4B93-AC82-D9069867A586}"/>
              </a:ext>
            </a:extLst>
          </p:cNvPr>
          <p:cNvSpPr txBox="1"/>
          <p:nvPr/>
        </p:nvSpPr>
        <p:spPr>
          <a:xfrm>
            <a:off x="3283850" y="2503193"/>
            <a:ext cx="1362458" cy="507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348" dirty="0">
                <a:latin typeface="Arial" panose="020B0604020202020204" pitchFamily="34" charset="0"/>
                <a:cs typeface="Arial" panose="020B0604020202020204" pitchFamily="34" charset="0"/>
              </a:rPr>
              <a:t>C1-INH/C1 </a:t>
            </a:r>
          </a:p>
          <a:p>
            <a:pPr algn="r"/>
            <a:r>
              <a:rPr lang="it-IT" sz="1348" dirty="0">
                <a:latin typeface="Arial" panose="020B0604020202020204" pitchFamily="34" charset="0"/>
                <a:cs typeface="Arial" panose="020B0604020202020204" pitchFamily="34" charset="0"/>
              </a:rPr>
              <a:t>ratio:</a:t>
            </a:r>
            <a:endParaRPr lang="en-US" sz="134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DB4C542-9090-48AC-A55E-9C634394B95F}"/>
              </a:ext>
            </a:extLst>
          </p:cNvPr>
          <p:cNvSpPr/>
          <p:nvPr/>
        </p:nvSpPr>
        <p:spPr>
          <a:xfrm>
            <a:off x="965200" y="5818887"/>
            <a:ext cx="11277600" cy="19784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.</a:t>
            </a:r>
            <a:r>
              <a:rPr lang="en-US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ffect of different C1-INH/C1 ratios on C4 cleavage. </a:t>
            </a:r>
            <a:r>
              <a:rPr lang="hu-HU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4 cleavage was detected by 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ting at different ratios of C1-INH/C1</a:t>
            </a:r>
            <a:r>
              <a:rPr lang="hu-HU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-incubated with 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4. Specific activation of C1 was induced by heat-aggregated gamma-globulin (HAGG). C4 composed by chain </a:t>
            </a:r>
            <a:r>
              <a:rPr lang="en-US" sz="2100" dirty="0">
                <a:solidFill>
                  <a:srgbClr val="000000"/>
                </a:solidFill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100" dirty="0">
                <a:solidFill>
                  <a:srgbClr val="000000"/>
                </a:solidFill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100" dirty="0">
                <a:solidFill>
                  <a:srgbClr val="000000"/>
                </a:solidFill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hu-HU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leavage</a:t>
            </a:r>
            <a:r>
              <a:rPr lang="hu-HU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 to </a:t>
            </a:r>
            <a:r>
              <a:rPr lang="en-US" sz="2100" dirty="0">
                <a:solidFill>
                  <a:srgbClr val="000000"/>
                </a:solidFill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´ and C4a.</a:t>
            </a:r>
            <a:endParaRPr lang="en-GB" sz="2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6126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42905" y="443089"/>
            <a:ext cx="5209820" cy="62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3467" dirty="0"/>
              <a:t>Suppl</a:t>
            </a:r>
            <a:r>
              <a:rPr lang="de-AT" sz="3467" dirty="0"/>
              <a:t>ementary</a:t>
            </a:r>
            <a:r>
              <a:rPr lang="hu-HU" sz="3467" dirty="0"/>
              <a:t> Fi</a:t>
            </a:r>
            <a:r>
              <a:rPr lang="de-AT" sz="3467" dirty="0"/>
              <a:t>gure 4</a:t>
            </a:r>
            <a:endParaRPr lang="en-US" sz="3467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DB4C542-9090-48AC-A55E-9C634394B95F}"/>
              </a:ext>
            </a:extLst>
          </p:cNvPr>
          <p:cNvSpPr/>
          <p:nvPr/>
        </p:nvSpPr>
        <p:spPr>
          <a:xfrm>
            <a:off x="965200" y="5818887"/>
            <a:ext cx="11277600" cy="25160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. Activity of rCP after thermal treatments. 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activity of rCP after three freeze-thaw cycles (3X FT), after </a:t>
            </a:r>
            <a:r>
              <a:rPr lang="en-US" sz="2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cubation</a:t>
            </a:r>
            <a:r>
              <a:rPr lang="hu-HU" sz="2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8 hours at 4°C (4°C 48 h) or </a:t>
            </a:r>
            <a:r>
              <a:rPr lang="hu-HU" sz="21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4 hours at 37°C (37°C 24 h) was evaluated by ELISA. The bars show the mean of the C5b-9 deposition relative to untreated rCP ±SEM of 3 independent experiments performed with duplicates. Results were compared with paired t-test (*P&lt; 0.05).</a:t>
            </a:r>
            <a:endParaRPr lang="en-GB" sz="2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5E2E8C8E-EF8A-4FBA-B5A7-50BED41839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5881526"/>
              </p:ext>
            </p:extLst>
          </p:nvPr>
        </p:nvGraphicFramePr>
        <p:xfrm>
          <a:off x="3463925" y="1725613"/>
          <a:ext cx="6280150" cy="3435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1" name="Prism 6" r:id="rId4" imgW="4551035" imgH="2489745" progId="Prism6.Document">
                  <p:embed/>
                </p:oleObj>
              </mc:Choice>
              <mc:Fallback>
                <p:oleObj name="Prism 6" r:id="rId4" imgW="4551035" imgH="2489745" progId="Prism6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F95DBF5-F606-486C-B260-6743444703B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63925" y="1725613"/>
                        <a:ext cx="6280150" cy="3435350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952453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ADE8BE7-4382-49D7-B50A-3ABDC89AF9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0531821"/>
              </p:ext>
            </p:extLst>
          </p:nvPr>
        </p:nvGraphicFramePr>
        <p:xfrm>
          <a:off x="2700402" y="1326216"/>
          <a:ext cx="7845307" cy="54262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6" r:id="rId4" imgW="3884784" imgH="2817485" progId="Prism6.Document">
                  <p:embed/>
                </p:oleObj>
              </mc:Choice>
              <mc:Fallback>
                <p:oleObj name="Prism 6" r:id="rId4" imgW="3884784" imgH="2817485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FADE8BE7-4382-49D7-B50A-3ABDC89AF990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00402" y="1326216"/>
                        <a:ext cx="7845307" cy="542626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23855" y="690739"/>
            <a:ext cx="5209820" cy="62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3467" dirty="0"/>
              <a:t>Suppl</a:t>
            </a:r>
            <a:r>
              <a:rPr lang="de-AT" sz="3467" dirty="0"/>
              <a:t>ementary</a:t>
            </a:r>
            <a:r>
              <a:rPr lang="hu-HU" sz="3467" dirty="0"/>
              <a:t> Fi</a:t>
            </a:r>
            <a:r>
              <a:rPr lang="de-AT" sz="3467" dirty="0"/>
              <a:t>gure 5</a:t>
            </a:r>
            <a:endParaRPr lang="en-US" sz="3467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C670595B-DB1D-499F-98E1-02CA624B9A6B}"/>
              </a:ext>
            </a:extLst>
          </p:cNvPr>
          <p:cNvSpPr/>
          <p:nvPr/>
        </p:nvSpPr>
        <p:spPr>
          <a:xfrm>
            <a:off x="965200" y="6533942"/>
            <a:ext cx="11277600" cy="14937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. Surface staining of </a:t>
            </a:r>
            <a:r>
              <a:rPr lang="en-US" sz="2100" b="1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G1655. 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cteria were coated with 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VIg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airYg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®) (red) or the Fab derived from this (blue). The filled circle indicates the signal of the secondary anti-Fab domain, while the open circles show the signal of the secondary anti-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n-US" sz="2100" dirty="0" err="1">
                <a:solidFill>
                  <a:srgbClr val="000000"/>
                </a:solidFill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2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52303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515F5F2-3A4F-4C0F-9E19-43678594223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70" t="20628" r="37073" b="46788"/>
          <a:stretch/>
        </p:blipFill>
        <p:spPr>
          <a:xfrm>
            <a:off x="3796307" y="2730401"/>
            <a:ext cx="5648691" cy="347051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AC7849A-810C-4273-A249-C8BDDD1984A1}"/>
              </a:ext>
            </a:extLst>
          </p:cNvPr>
          <p:cNvSpPr txBox="1"/>
          <p:nvPr/>
        </p:nvSpPr>
        <p:spPr>
          <a:xfrm rot="18622021">
            <a:off x="3575383" y="1583464"/>
            <a:ext cx="2673769" cy="3886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926" dirty="0"/>
              <a:t>albumin</a:t>
            </a:r>
            <a:endParaRPr lang="en-US" sz="1926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799132C-30D5-49FC-A23A-5588E2E31766}"/>
              </a:ext>
            </a:extLst>
          </p:cNvPr>
          <p:cNvSpPr txBox="1"/>
          <p:nvPr/>
        </p:nvSpPr>
        <p:spPr>
          <a:xfrm rot="18622021">
            <a:off x="4284154" y="1397935"/>
            <a:ext cx="3046900" cy="3886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926" dirty="0" err="1"/>
              <a:t>clairYG</a:t>
            </a:r>
            <a:r>
              <a:rPr lang="en-GB" sz="1926" dirty="0"/>
              <a:t> 50 </a:t>
            </a:r>
            <a:r>
              <a:rPr lang="en-GB" sz="1926" dirty="0" err="1"/>
              <a:t>ug</a:t>
            </a:r>
            <a:r>
              <a:rPr lang="en-GB" sz="1926" dirty="0"/>
              <a:t>/mL</a:t>
            </a:r>
            <a:endParaRPr lang="en-US" sz="1926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4AC493A-31E7-4313-8E1A-BF4C86E53D1D}"/>
              </a:ext>
            </a:extLst>
          </p:cNvPr>
          <p:cNvSpPr txBox="1"/>
          <p:nvPr/>
        </p:nvSpPr>
        <p:spPr>
          <a:xfrm rot="18622021">
            <a:off x="5940577" y="1400492"/>
            <a:ext cx="3046900" cy="3886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926" dirty="0" err="1"/>
              <a:t>rAP</a:t>
            </a:r>
            <a:endParaRPr lang="en-US" sz="1926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4941643-CBFC-4AB4-96CA-D00A04C91DA3}"/>
              </a:ext>
            </a:extLst>
          </p:cNvPr>
          <p:cNvSpPr txBox="1"/>
          <p:nvPr/>
        </p:nvSpPr>
        <p:spPr>
          <a:xfrm rot="18622021">
            <a:off x="6831324" y="1403043"/>
            <a:ext cx="3046900" cy="3886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926" dirty="0" err="1"/>
              <a:t>rCP</a:t>
            </a:r>
            <a:endParaRPr lang="en-US" sz="1926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E15773A-144A-49A0-BD9B-E17571D41F81}"/>
              </a:ext>
            </a:extLst>
          </p:cNvPr>
          <p:cNvSpPr txBox="1"/>
          <p:nvPr/>
        </p:nvSpPr>
        <p:spPr>
          <a:xfrm rot="18622021">
            <a:off x="7899775" y="1359654"/>
            <a:ext cx="3046900" cy="3886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926" dirty="0" err="1"/>
              <a:t>rAP+rCP</a:t>
            </a:r>
            <a:endParaRPr lang="en-US" sz="1926" dirty="0"/>
          </a:p>
        </p:txBody>
      </p:sp>
      <p:sp>
        <p:nvSpPr>
          <p:cNvPr id="17" name="TextBox 16"/>
          <p:cNvSpPr txBox="1"/>
          <p:nvPr/>
        </p:nvSpPr>
        <p:spPr>
          <a:xfrm>
            <a:off x="361955" y="595489"/>
            <a:ext cx="5209820" cy="62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3467" dirty="0"/>
              <a:t>Suppl</a:t>
            </a:r>
            <a:r>
              <a:rPr lang="de-AT" sz="3467" dirty="0"/>
              <a:t>ementary</a:t>
            </a:r>
            <a:r>
              <a:rPr lang="hu-HU" sz="3467" dirty="0"/>
              <a:t> Fi</a:t>
            </a:r>
            <a:r>
              <a:rPr lang="de-AT" sz="3467" dirty="0"/>
              <a:t>gure 6</a:t>
            </a:r>
            <a:endParaRPr lang="en-US" sz="3467" dirty="0"/>
          </a:p>
        </p:txBody>
      </p:sp>
      <p:sp>
        <p:nvSpPr>
          <p:cNvPr id="37" name="Isosceles Triangle 36">
            <a:extLst>
              <a:ext uri="{FF2B5EF4-FFF2-40B4-BE49-F238E27FC236}">
                <a16:creationId xmlns:a16="http://schemas.microsoft.com/office/drawing/2014/main" id="{B80E85DC-CFE0-4762-BFCC-85A48ED9A50A}"/>
              </a:ext>
            </a:extLst>
          </p:cNvPr>
          <p:cNvSpPr>
            <a:spLocks/>
          </p:cNvSpPr>
          <p:nvPr/>
        </p:nvSpPr>
        <p:spPr>
          <a:xfrm rot="5400000">
            <a:off x="3530195" y="4219328"/>
            <a:ext cx="73291" cy="14788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467"/>
          </a:p>
        </p:txBody>
      </p:sp>
      <p:sp>
        <p:nvSpPr>
          <p:cNvPr id="38" name="Isosceles Triangle 37">
            <a:extLst>
              <a:ext uri="{FF2B5EF4-FFF2-40B4-BE49-F238E27FC236}">
                <a16:creationId xmlns:a16="http://schemas.microsoft.com/office/drawing/2014/main" id="{D79533EF-AAD8-4429-91E5-1EE3AF670378}"/>
              </a:ext>
            </a:extLst>
          </p:cNvPr>
          <p:cNvSpPr>
            <a:spLocks/>
          </p:cNvSpPr>
          <p:nvPr/>
        </p:nvSpPr>
        <p:spPr>
          <a:xfrm rot="5400000">
            <a:off x="3514068" y="4481369"/>
            <a:ext cx="73291" cy="14788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467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9F96805-5EB0-4EE7-8AED-C46BC81ECFF0}"/>
              </a:ext>
            </a:extLst>
          </p:cNvPr>
          <p:cNvSpPr txBox="1"/>
          <p:nvPr/>
        </p:nvSpPr>
        <p:spPr>
          <a:xfrm>
            <a:off x="2711490" y="4040177"/>
            <a:ext cx="958659" cy="3886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926" dirty="0">
                <a:latin typeface="Arial" panose="020B0604020202020204" pitchFamily="34" charset="0"/>
                <a:cs typeface="Arial" panose="020B0604020202020204" pitchFamily="34" charset="0"/>
              </a:rPr>
              <a:t>HSA</a:t>
            </a:r>
            <a:endParaRPr lang="en-US" sz="192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913A58E-EAD1-4A8A-8850-475A7501A3C1}"/>
              </a:ext>
            </a:extLst>
          </p:cNvPr>
          <p:cNvGrpSpPr/>
          <p:nvPr/>
        </p:nvGrpSpPr>
        <p:grpSpPr>
          <a:xfrm>
            <a:off x="2913647" y="5510556"/>
            <a:ext cx="882660" cy="388696"/>
            <a:chOff x="1354594" y="2679007"/>
            <a:chExt cx="458304" cy="201823"/>
          </a:xfrm>
        </p:grpSpPr>
        <p:sp>
          <p:nvSpPr>
            <p:cNvPr id="39" name="Isosceles Triangle 38">
              <a:extLst>
                <a:ext uri="{FF2B5EF4-FFF2-40B4-BE49-F238E27FC236}">
                  <a16:creationId xmlns:a16="http://schemas.microsoft.com/office/drawing/2014/main" id="{4119E3E3-6CDA-4904-9654-18A09418646B}"/>
                </a:ext>
              </a:extLst>
            </p:cNvPr>
            <p:cNvSpPr>
              <a:spLocks/>
            </p:cNvSpPr>
            <p:nvPr/>
          </p:nvSpPr>
          <p:spPr>
            <a:xfrm rot="5400000">
              <a:off x="1678073" y="2771223"/>
              <a:ext cx="38055" cy="76788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67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FE5DB57-FA5C-4AE5-9FB9-656D31F05AF0}"/>
                </a:ext>
              </a:extLst>
            </p:cNvPr>
            <p:cNvSpPr txBox="1"/>
            <p:nvPr/>
          </p:nvSpPr>
          <p:spPr>
            <a:xfrm>
              <a:off x="1354594" y="2679007"/>
              <a:ext cx="458304" cy="2018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926" dirty="0">
                  <a:latin typeface="Arial" panose="020B0604020202020204" pitchFamily="34" charset="0"/>
                  <a:cs typeface="Arial" panose="020B0604020202020204" pitchFamily="34" charset="0"/>
                </a:rPr>
                <a:t>LC</a:t>
              </a:r>
              <a:endParaRPr lang="en-US" sz="192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D2103201-37B0-4B99-BF0C-2F41CA5A14D0}"/>
              </a:ext>
            </a:extLst>
          </p:cNvPr>
          <p:cNvSpPr txBox="1"/>
          <p:nvPr/>
        </p:nvSpPr>
        <p:spPr>
          <a:xfrm>
            <a:off x="2848777" y="4333688"/>
            <a:ext cx="978155" cy="3886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926" dirty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endParaRPr lang="en-US" sz="192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B73CDE4-4C7A-4C10-B5A1-B47324F03A2D}"/>
              </a:ext>
            </a:extLst>
          </p:cNvPr>
          <p:cNvSpPr/>
          <p:nvPr/>
        </p:nvSpPr>
        <p:spPr>
          <a:xfrm>
            <a:off x="974326" y="6470846"/>
            <a:ext cx="11325623" cy="19795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6. Detection of IgG and albumin in </a:t>
            </a:r>
            <a:r>
              <a:rPr lang="en-US" sz="21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P</a:t>
            </a:r>
            <a:r>
              <a:rPr lang="en-US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1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CP</a:t>
            </a:r>
            <a:r>
              <a:rPr lang="en-US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1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P+rCP</a:t>
            </a:r>
            <a:r>
              <a:rPr lang="en-US" sz="2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reparations. 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presence of IgG in 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P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CP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P+rCP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tested by immunoblot detecting IgG (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n-US" sz="2100" dirty="0" err="1">
                <a:solidFill>
                  <a:srgbClr val="000000"/>
                </a:solidFill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eavy chain, HC and light chain, LC). Albumin (HSA) was used as loading control and detected with a specific antibody. All samples were diluted 1:400 except </a:t>
            </a:r>
            <a:r>
              <a:rPr lang="en-US" sz="2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airYg</a:t>
            </a:r>
            <a:r>
              <a:rPr lang="en-US" sz="2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positive control).</a:t>
            </a:r>
            <a:endParaRPr lang="en-GB" sz="2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3400646"/>
      </p:ext>
    </p:extLst>
  </p:cSld>
  <p:clrMapOvr>
    <a:masterClrMapping/>
  </p:clrMapOvr>
</p:sld>
</file>

<file path=ppt/theme/theme1.xml><?xml version="1.0" encoding="utf-8"?>
<a:theme xmlns:a="http://schemas.openxmlformats.org/drawingml/2006/main" name="Arsanis Master Template 2017">
  <a:themeElements>
    <a:clrScheme name="Custom 86">
      <a:dk1>
        <a:srgbClr val="635E59"/>
      </a:dk1>
      <a:lt1>
        <a:sysClr val="window" lastClr="FFFFFF"/>
      </a:lt1>
      <a:dk2>
        <a:srgbClr val="000000"/>
      </a:dk2>
      <a:lt2>
        <a:srgbClr val="EEECE1"/>
      </a:lt2>
      <a:accent1>
        <a:srgbClr val="3064AF"/>
      </a:accent1>
      <a:accent2>
        <a:srgbClr val="FF543F"/>
      </a:accent2>
      <a:accent3>
        <a:srgbClr val="0BADA5"/>
      </a:accent3>
      <a:accent4>
        <a:srgbClr val="698799"/>
      </a:accent4>
      <a:accent5>
        <a:srgbClr val="7BC68A"/>
      </a:accent5>
      <a:accent6>
        <a:srgbClr val="FF8500"/>
      </a:accent6>
      <a:hlink>
        <a:srgbClr val="3064AF"/>
      </a:hlink>
      <a:folHlink>
        <a:srgbClr val="0BADA5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/>
        </a:solidFill>
        <a:ln>
          <a:noFill/>
        </a:ln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>
        <a:ln w="12700" cmpd="sng">
          <a:solidFill>
            <a:schemeClr val="tx1"/>
          </a:solidFill>
        </a:ln>
        <a:effectLst/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dirty="0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Arsanis Corporate Template 2018" id="{5207DAE5-8833-4374-AA86-81C54616231B}" vid="{BF47B419-5725-4DF1-BE3A-C2FA1A0A9879}"/>
    </a:ext>
  </a:extLst>
</a:theme>
</file>

<file path=ppt/theme/theme2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rsanis Corporate Template 2018</Template>
  <TotalTime>0</TotalTime>
  <Words>537</Words>
  <Application>Microsoft Office PowerPoint</Application>
  <PresentationFormat>Custom</PresentationFormat>
  <Paragraphs>30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Calibri</vt:lpstr>
      <vt:lpstr>Calibri Light</vt:lpstr>
      <vt:lpstr>Symbol</vt:lpstr>
      <vt:lpstr>Times New Roman</vt:lpstr>
      <vt:lpstr>Arsanis Master Template 2017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ele.mutti</dc:creator>
  <dc:description>Developed by The NemetzGroup LLC_x000d_July 8, 2016</dc:description>
  <cp:lastModifiedBy>Michele Mutti</cp:lastModifiedBy>
  <cp:revision>440</cp:revision>
  <cp:lastPrinted>2018-05-16T08:15:12Z</cp:lastPrinted>
  <dcterms:created xsi:type="dcterms:W3CDTF">2018-03-01T13:56:20Z</dcterms:created>
  <dcterms:modified xsi:type="dcterms:W3CDTF">2018-08-20T16:47:11Z</dcterms:modified>
</cp:coreProperties>
</file>